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8" r:id="rId3"/>
    <p:sldId id="260" r:id="rId4"/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4F941C4-982E-4BD8-A72E-B5713F333B4F}" v="46" dt="2025-02-04T18:23:49.623"/>
    <p1510:client id="{6E8F1066-66C8-4F20-B65F-E4F21373EF63}" v="45" dt="2025-02-04T16:46:11.55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67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Qinghe Meng" userId="8ec5781b-3938-43df-a84f-730d81e9a524" providerId="ADAL" clId="{54F941C4-982E-4BD8-A72E-B5713F333B4F}"/>
    <pc:docChg chg="undo custSel modSld sldOrd">
      <pc:chgData name="Qinghe Meng" userId="8ec5781b-3938-43df-a84f-730d81e9a524" providerId="ADAL" clId="{54F941C4-982E-4BD8-A72E-B5713F333B4F}" dt="2025-02-04T18:24:11.222" v="447" actId="14100"/>
      <pc:docMkLst>
        <pc:docMk/>
      </pc:docMkLst>
      <pc:sldChg chg="addSp modSp mod ord">
        <pc:chgData name="Qinghe Meng" userId="8ec5781b-3938-43df-a84f-730d81e9a524" providerId="ADAL" clId="{54F941C4-982E-4BD8-A72E-B5713F333B4F}" dt="2025-02-04T18:24:11.222" v="447" actId="14100"/>
        <pc:sldMkLst>
          <pc:docMk/>
          <pc:sldMk cId="1456787092" sldId="256"/>
        </pc:sldMkLst>
        <pc:spChg chg="add mod">
          <ac:chgData name="Qinghe Meng" userId="8ec5781b-3938-43df-a84f-730d81e9a524" providerId="ADAL" clId="{54F941C4-982E-4BD8-A72E-B5713F333B4F}" dt="2025-02-04T18:24:11.222" v="447" actId="14100"/>
          <ac:spMkLst>
            <pc:docMk/>
            <pc:sldMk cId="1456787092" sldId="256"/>
            <ac:spMk id="2" creationId="{3F8E04B9-3C10-A811-0F9C-6D3AE3D66820}"/>
          </ac:spMkLst>
        </pc:spChg>
        <pc:spChg chg="mod">
          <ac:chgData name="Qinghe Meng" userId="8ec5781b-3938-43df-a84f-730d81e9a524" providerId="ADAL" clId="{54F941C4-982E-4BD8-A72E-B5713F333B4F}" dt="2025-02-04T18:23:42.472" v="426" actId="1076"/>
          <ac:spMkLst>
            <pc:docMk/>
            <pc:sldMk cId="1456787092" sldId="256"/>
            <ac:spMk id="35" creationId="{A960DDA4-41EE-096A-8604-7B5A2FE0E42F}"/>
          </ac:spMkLst>
        </pc:spChg>
        <pc:spChg chg="mod">
          <ac:chgData name="Qinghe Meng" userId="8ec5781b-3938-43df-a84f-730d81e9a524" providerId="ADAL" clId="{54F941C4-982E-4BD8-A72E-B5713F333B4F}" dt="2025-02-04T18:23:42.472" v="426" actId="1076"/>
          <ac:spMkLst>
            <pc:docMk/>
            <pc:sldMk cId="1456787092" sldId="256"/>
            <ac:spMk id="36" creationId="{EAB3AD6E-5D02-BE11-C6BC-1CC08D5BB87E}"/>
          </ac:spMkLst>
        </pc:spChg>
        <pc:spChg chg="mod">
          <ac:chgData name="Qinghe Meng" userId="8ec5781b-3938-43df-a84f-730d81e9a524" providerId="ADAL" clId="{54F941C4-982E-4BD8-A72E-B5713F333B4F}" dt="2025-02-04T18:23:42.472" v="426" actId="1076"/>
          <ac:spMkLst>
            <pc:docMk/>
            <pc:sldMk cId="1456787092" sldId="256"/>
            <ac:spMk id="37" creationId="{E5B5D775-1D6A-19AA-D13B-B871FEFCDB07}"/>
          </ac:spMkLst>
        </pc:spChg>
        <pc:picChg chg="mod">
          <ac:chgData name="Qinghe Meng" userId="8ec5781b-3938-43df-a84f-730d81e9a524" providerId="ADAL" clId="{54F941C4-982E-4BD8-A72E-B5713F333B4F}" dt="2025-02-04T18:23:42.472" v="426" actId="1076"/>
          <ac:picMkLst>
            <pc:docMk/>
            <pc:sldMk cId="1456787092" sldId="256"/>
            <ac:picMk id="5" creationId="{40252628-585F-C1B2-360E-66339136B7CD}"/>
          </ac:picMkLst>
        </pc:picChg>
        <pc:picChg chg="mod">
          <ac:chgData name="Qinghe Meng" userId="8ec5781b-3938-43df-a84f-730d81e9a524" providerId="ADAL" clId="{54F941C4-982E-4BD8-A72E-B5713F333B4F}" dt="2025-02-04T18:23:42.472" v="426" actId="1076"/>
          <ac:picMkLst>
            <pc:docMk/>
            <pc:sldMk cId="1456787092" sldId="256"/>
            <ac:picMk id="7" creationId="{B34254CD-35B6-05A9-89EE-39E1F725A620}"/>
          </ac:picMkLst>
        </pc:picChg>
        <pc:picChg chg="mod">
          <ac:chgData name="Qinghe Meng" userId="8ec5781b-3938-43df-a84f-730d81e9a524" providerId="ADAL" clId="{54F941C4-982E-4BD8-A72E-B5713F333B4F}" dt="2025-02-04T18:23:42.472" v="426" actId="1076"/>
          <ac:picMkLst>
            <pc:docMk/>
            <pc:sldMk cId="1456787092" sldId="256"/>
            <ac:picMk id="9" creationId="{822E53C8-F791-5A6E-D963-9B77FA43997E}"/>
          </ac:picMkLst>
        </pc:picChg>
        <pc:picChg chg="mod">
          <ac:chgData name="Qinghe Meng" userId="8ec5781b-3938-43df-a84f-730d81e9a524" providerId="ADAL" clId="{54F941C4-982E-4BD8-A72E-B5713F333B4F}" dt="2025-02-04T18:23:42.472" v="426" actId="1076"/>
          <ac:picMkLst>
            <pc:docMk/>
            <pc:sldMk cId="1456787092" sldId="256"/>
            <ac:picMk id="11" creationId="{CE4DCD68-75F0-FA8B-E46D-55FE059C79EA}"/>
          </ac:picMkLst>
        </pc:picChg>
        <pc:picChg chg="mod">
          <ac:chgData name="Qinghe Meng" userId="8ec5781b-3938-43df-a84f-730d81e9a524" providerId="ADAL" clId="{54F941C4-982E-4BD8-A72E-B5713F333B4F}" dt="2025-02-04T18:23:42.472" v="426" actId="1076"/>
          <ac:picMkLst>
            <pc:docMk/>
            <pc:sldMk cId="1456787092" sldId="256"/>
            <ac:picMk id="13" creationId="{2D525212-891B-D1A0-64FB-FC5EE4AD8F18}"/>
          </ac:picMkLst>
        </pc:picChg>
        <pc:picChg chg="mod">
          <ac:chgData name="Qinghe Meng" userId="8ec5781b-3938-43df-a84f-730d81e9a524" providerId="ADAL" clId="{54F941C4-982E-4BD8-A72E-B5713F333B4F}" dt="2025-02-04T18:23:42.472" v="426" actId="1076"/>
          <ac:picMkLst>
            <pc:docMk/>
            <pc:sldMk cId="1456787092" sldId="256"/>
            <ac:picMk id="15" creationId="{6CE8D2F7-035B-5CED-8D06-0AF1E461782E}"/>
          </ac:picMkLst>
        </pc:picChg>
        <pc:picChg chg="mod">
          <ac:chgData name="Qinghe Meng" userId="8ec5781b-3938-43df-a84f-730d81e9a524" providerId="ADAL" clId="{54F941C4-982E-4BD8-A72E-B5713F333B4F}" dt="2025-02-04T18:23:42.472" v="426" actId="1076"/>
          <ac:picMkLst>
            <pc:docMk/>
            <pc:sldMk cId="1456787092" sldId="256"/>
            <ac:picMk id="17" creationId="{9961F391-0D83-AA75-3CF0-735FB5EC2B77}"/>
          </ac:picMkLst>
        </pc:picChg>
        <pc:picChg chg="mod">
          <ac:chgData name="Qinghe Meng" userId="8ec5781b-3938-43df-a84f-730d81e9a524" providerId="ADAL" clId="{54F941C4-982E-4BD8-A72E-B5713F333B4F}" dt="2025-02-04T18:23:42.472" v="426" actId="1076"/>
          <ac:picMkLst>
            <pc:docMk/>
            <pc:sldMk cId="1456787092" sldId="256"/>
            <ac:picMk id="23" creationId="{E106BEF0-15F8-3FA0-E657-92B8C3F908D2}"/>
          </ac:picMkLst>
        </pc:picChg>
        <pc:picChg chg="mod">
          <ac:chgData name="Qinghe Meng" userId="8ec5781b-3938-43df-a84f-730d81e9a524" providerId="ADAL" clId="{54F941C4-982E-4BD8-A72E-B5713F333B4F}" dt="2025-02-04T18:23:42.472" v="426" actId="1076"/>
          <ac:picMkLst>
            <pc:docMk/>
            <pc:sldMk cId="1456787092" sldId="256"/>
            <ac:picMk id="27" creationId="{E5AEB199-AFF8-66C8-2F05-2DACCCDC43F5}"/>
          </ac:picMkLst>
        </pc:picChg>
        <pc:picChg chg="mod">
          <ac:chgData name="Qinghe Meng" userId="8ec5781b-3938-43df-a84f-730d81e9a524" providerId="ADAL" clId="{54F941C4-982E-4BD8-A72E-B5713F333B4F}" dt="2025-02-04T18:23:42.472" v="426" actId="1076"/>
          <ac:picMkLst>
            <pc:docMk/>
            <pc:sldMk cId="1456787092" sldId="256"/>
            <ac:picMk id="29" creationId="{CE45560D-A1B2-0E31-45D7-6CE1D0465079}"/>
          </ac:picMkLst>
        </pc:picChg>
        <pc:picChg chg="mod">
          <ac:chgData name="Qinghe Meng" userId="8ec5781b-3938-43df-a84f-730d81e9a524" providerId="ADAL" clId="{54F941C4-982E-4BD8-A72E-B5713F333B4F}" dt="2025-02-04T18:23:42.472" v="426" actId="1076"/>
          <ac:picMkLst>
            <pc:docMk/>
            <pc:sldMk cId="1456787092" sldId="256"/>
            <ac:picMk id="31" creationId="{B003F28B-E926-1196-0A65-B67A878A542D}"/>
          </ac:picMkLst>
        </pc:picChg>
        <pc:picChg chg="mod">
          <ac:chgData name="Qinghe Meng" userId="8ec5781b-3938-43df-a84f-730d81e9a524" providerId="ADAL" clId="{54F941C4-982E-4BD8-A72E-B5713F333B4F}" dt="2025-02-04T18:23:42.472" v="426" actId="1076"/>
          <ac:picMkLst>
            <pc:docMk/>
            <pc:sldMk cId="1456787092" sldId="256"/>
            <ac:picMk id="33" creationId="{804A2604-CB76-5F45-BA3C-D9C57A9DD968}"/>
          </ac:picMkLst>
        </pc:picChg>
      </pc:sldChg>
      <pc:sldChg chg="addSp delSp modSp mod">
        <pc:chgData name="Qinghe Meng" userId="8ec5781b-3938-43df-a84f-730d81e9a524" providerId="ADAL" clId="{54F941C4-982E-4BD8-A72E-B5713F333B4F}" dt="2025-02-04T17:43:53.419" v="365" actId="1076"/>
        <pc:sldMkLst>
          <pc:docMk/>
          <pc:sldMk cId="1576708807" sldId="258"/>
        </pc:sldMkLst>
        <pc:spChg chg="add mod">
          <ac:chgData name="Qinghe Meng" userId="8ec5781b-3938-43df-a84f-730d81e9a524" providerId="ADAL" clId="{54F941C4-982E-4BD8-A72E-B5713F333B4F}" dt="2025-02-04T17:43:53.419" v="365" actId="1076"/>
          <ac:spMkLst>
            <pc:docMk/>
            <pc:sldMk cId="1576708807" sldId="258"/>
            <ac:spMk id="2" creationId="{5F464FFE-10A5-ACF7-EF68-BBA37AC03FC8}"/>
          </ac:spMkLst>
        </pc:spChg>
        <pc:spChg chg="add mod">
          <ac:chgData name="Qinghe Meng" userId="8ec5781b-3938-43df-a84f-730d81e9a524" providerId="ADAL" clId="{54F941C4-982E-4BD8-A72E-B5713F333B4F}" dt="2025-02-04T17:43:49.213" v="364" actId="1076"/>
          <ac:spMkLst>
            <pc:docMk/>
            <pc:sldMk cId="1576708807" sldId="258"/>
            <ac:spMk id="3" creationId="{EB2B8011-358C-DFD3-37A7-6A884E0F5C35}"/>
          </ac:spMkLst>
        </pc:spChg>
        <pc:spChg chg="add mod">
          <ac:chgData name="Qinghe Meng" userId="8ec5781b-3938-43df-a84f-730d81e9a524" providerId="ADAL" clId="{54F941C4-982E-4BD8-A72E-B5713F333B4F}" dt="2025-02-04T17:43:46.499" v="363" actId="1076"/>
          <ac:spMkLst>
            <pc:docMk/>
            <pc:sldMk cId="1576708807" sldId="258"/>
            <ac:spMk id="4" creationId="{568BD4D7-B540-A975-7141-28C3A9F92D42}"/>
          </ac:spMkLst>
        </pc:spChg>
        <pc:spChg chg="add mod">
          <ac:chgData name="Qinghe Meng" userId="8ec5781b-3938-43df-a84f-730d81e9a524" providerId="ADAL" clId="{54F941C4-982E-4BD8-A72E-B5713F333B4F}" dt="2025-02-04T17:43:43.886" v="362" actId="1076"/>
          <ac:spMkLst>
            <pc:docMk/>
            <pc:sldMk cId="1576708807" sldId="258"/>
            <ac:spMk id="5" creationId="{F95425E9-6EA8-5CEA-5B25-E7276112EF2D}"/>
          </ac:spMkLst>
        </pc:spChg>
        <pc:spChg chg="mod">
          <ac:chgData name="Qinghe Meng" userId="8ec5781b-3938-43df-a84f-730d81e9a524" providerId="ADAL" clId="{54F941C4-982E-4BD8-A72E-B5713F333B4F}" dt="2025-02-04T17:41:56.152" v="300" actId="1076"/>
          <ac:spMkLst>
            <pc:docMk/>
            <pc:sldMk cId="1576708807" sldId="258"/>
            <ac:spMk id="14" creationId="{FAFCAAA8-6CDD-EDE8-7F84-81D0C339925D}"/>
          </ac:spMkLst>
        </pc:spChg>
        <pc:spChg chg="mod">
          <ac:chgData name="Qinghe Meng" userId="8ec5781b-3938-43df-a84f-730d81e9a524" providerId="ADAL" clId="{54F941C4-982E-4BD8-A72E-B5713F333B4F}" dt="2025-02-04T17:41:59.619" v="301" actId="20577"/>
          <ac:spMkLst>
            <pc:docMk/>
            <pc:sldMk cId="1576708807" sldId="258"/>
            <ac:spMk id="32" creationId="{A1CD494D-4889-6965-1506-6164E8FB02E0}"/>
          </ac:spMkLst>
        </pc:spChg>
        <pc:spChg chg="mod">
          <ac:chgData name="Qinghe Meng" userId="8ec5781b-3938-43df-a84f-730d81e9a524" providerId="ADAL" clId="{54F941C4-982E-4BD8-A72E-B5713F333B4F}" dt="2025-02-04T17:42:00.807" v="302" actId="20577"/>
          <ac:spMkLst>
            <pc:docMk/>
            <pc:sldMk cId="1576708807" sldId="258"/>
            <ac:spMk id="33" creationId="{D3637729-3E45-1BD0-7CEF-1F8A185E5551}"/>
          </ac:spMkLst>
        </pc:spChg>
        <pc:spChg chg="mod">
          <ac:chgData name="Qinghe Meng" userId="8ec5781b-3938-43df-a84f-730d81e9a524" providerId="ADAL" clId="{54F941C4-982E-4BD8-A72E-B5713F333B4F}" dt="2025-02-04T17:42:02.453" v="303" actId="20577"/>
          <ac:spMkLst>
            <pc:docMk/>
            <pc:sldMk cId="1576708807" sldId="258"/>
            <ac:spMk id="35" creationId="{209A6706-3F84-7F0A-7B15-AFF0713E9D21}"/>
          </ac:spMkLst>
        </pc:spChg>
        <pc:spChg chg="mod">
          <ac:chgData name="Qinghe Meng" userId="8ec5781b-3938-43df-a84f-730d81e9a524" providerId="ADAL" clId="{54F941C4-982E-4BD8-A72E-B5713F333B4F}" dt="2025-02-04T17:42:03.557" v="304" actId="20577"/>
          <ac:spMkLst>
            <pc:docMk/>
            <pc:sldMk cId="1576708807" sldId="258"/>
            <ac:spMk id="36" creationId="{92C835B6-5DFF-E142-D1E9-D9D9E6CD7C4A}"/>
          </ac:spMkLst>
        </pc:spChg>
        <pc:spChg chg="del">
          <ac:chgData name="Qinghe Meng" userId="8ec5781b-3938-43df-a84f-730d81e9a524" providerId="ADAL" clId="{54F941C4-982E-4BD8-A72E-B5713F333B4F}" dt="2025-02-04T17:43:29.604" v="354" actId="478"/>
          <ac:spMkLst>
            <pc:docMk/>
            <pc:sldMk cId="1576708807" sldId="258"/>
            <ac:spMk id="42" creationId="{1D4A2B66-A825-E6B7-AD63-95A97FB0F4A9}"/>
          </ac:spMkLst>
        </pc:spChg>
        <pc:spChg chg="del">
          <ac:chgData name="Qinghe Meng" userId="8ec5781b-3938-43df-a84f-730d81e9a524" providerId="ADAL" clId="{54F941C4-982E-4BD8-A72E-B5713F333B4F}" dt="2025-02-04T17:43:34.806" v="358" actId="478"/>
          <ac:spMkLst>
            <pc:docMk/>
            <pc:sldMk cId="1576708807" sldId="258"/>
            <ac:spMk id="43" creationId="{E99BDC04-E0A1-B3DD-4AE8-51F3861F1449}"/>
          </ac:spMkLst>
        </pc:spChg>
        <pc:spChg chg="del">
          <ac:chgData name="Qinghe Meng" userId="8ec5781b-3938-43df-a84f-730d81e9a524" providerId="ADAL" clId="{54F941C4-982E-4BD8-A72E-B5713F333B4F}" dt="2025-02-04T17:43:36.083" v="359" actId="478"/>
          <ac:spMkLst>
            <pc:docMk/>
            <pc:sldMk cId="1576708807" sldId="258"/>
            <ac:spMk id="44" creationId="{27EF9B84-196A-63EE-3495-A8926678E60A}"/>
          </ac:spMkLst>
        </pc:spChg>
        <pc:spChg chg="mod">
          <ac:chgData name="Qinghe Meng" userId="8ec5781b-3938-43df-a84f-730d81e9a524" providerId="ADAL" clId="{54F941C4-982E-4BD8-A72E-B5713F333B4F}" dt="2025-02-04T17:42:04.724" v="305" actId="20577"/>
          <ac:spMkLst>
            <pc:docMk/>
            <pc:sldMk cId="1576708807" sldId="258"/>
            <ac:spMk id="50" creationId="{9FF9BFB2-D4E6-3B90-C58C-29A484E88048}"/>
          </ac:spMkLst>
        </pc:spChg>
        <pc:spChg chg="mod">
          <ac:chgData name="Qinghe Meng" userId="8ec5781b-3938-43df-a84f-730d81e9a524" providerId="ADAL" clId="{54F941C4-982E-4BD8-A72E-B5713F333B4F}" dt="2025-02-04T17:42:08.324" v="307" actId="20577"/>
          <ac:spMkLst>
            <pc:docMk/>
            <pc:sldMk cId="1576708807" sldId="258"/>
            <ac:spMk id="51" creationId="{25961F17-3948-D762-D22E-D1B8E443D4C1}"/>
          </ac:spMkLst>
        </pc:spChg>
        <pc:spChg chg="mod">
          <ac:chgData name="Qinghe Meng" userId="8ec5781b-3938-43df-a84f-730d81e9a524" providerId="ADAL" clId="{54F941C4-982E-4BD8-A72E-B5713F333B4F}" dt="2025-02-04T17:42:12.501" v="308" actId="20577"/>
          <ac:spMkLst>
            <pc:docMk/>
            <pc:sldMk cId="1576708807" sldId="258"/>
            <ac:spMk id="52" creationId="{EFD9FD77-2E82-844A-20AB-63732012F0A9}"/>
          </ac:spMkLst>
        </pc:spChg>
        <pc:spChg chg="mod">
          <ac:chgData name="Qinghe Meng" userId="8ec5781b-3938-43df-a84f-730d81e9a524" providerId="ADAL" clId="{54F941C4-982E-4BD8-A72E-B5713F333B4F}" dt="2025-02-04T17:42:06.292" v="306" actId="20577"/>
          <ac:spMkLst>
            <pc:docMk/>
            <pc:sldMk cId="1576708807" sldId="258"/>
            <ac:spMk id="55" creationId="{E0814BFC-A6D1-CC73-6242-1918E3BBEB03}"/>
          </ac:spMkLst>
        </pc:spChg>
        <pc:spChg chg="del mod">
          <ac:chgData name="Qinghe Meng" userId="8ec5781b-3938-43df-a84f-730d81e9a524" providerId="ADAL" clId="{54F941C4-982E-4BD8-A72E-B5713F333B4F}" dt="2025-02-04T17:43:39.508" v="361" actId="478"/>
          <ac:spMkLst>
            <pc:docMk/>
            <pc:sldMk cId="1576708807" sldId="258"/>
            <ac:spMk id="57" creationId="{F5E177F5-FDA1-27C9-F2E1-FD9FEC13795E}"/>
          </ac:spMkLst>
        </pc:spChg>
      </pc:sldChg>
      <pc:sldChg chg="addSp delSp modSp mod ord">
        <pc:chgData name="Qinghe Meng" userId="8ec5781b-3938-43df-a84f-730d81e9a524" providerId="ADAL" clId="{54F941C4-982E-4BD8-A72E-B5713F333B4F}" dt="2025-02-04T17:44:08.617" v="366" actId="1076"/>
        <pc:sldMkLst>
          <pc:docMk/>
          <pc:sldMk cId="872520971" sldId="259"/>
        </pc:sldMkLst>
        <pc:spChg chg="mod">
          <ac:chgData name="Qinghe Meng" userId="8ec5781b-3938-43df-a84f-730d81e9a524" providerId="ADAL" clId="{54F941C4-982E-4BD8-A72E-B5713F333B4F}" dt="2025-02-04T17:34:50.285" v="141" actId="1076"/>
          <ac:spMkLst>
            <pc:docMk/>
            <pc:sldMk cId="872520971" sldId="259"/>
            <ac:spMk id="4" creationId="{877275E2-1592-3FBD-A9B2-E7959478E01D}"/>
          </ac:spMkLst>
        </pc:spChg>
        <pc:spChg chg="add mod">
          <ac:chgData name="Qinghe Meng" userId="8ec5781b-3938-43df-a84f-730d81e9a524" providerId="ADAL" clId="{54F941C4-982E-4BD8-A72E-B5713F333B4F}" dt="2025-02-04T17:39:43.393" v="251" actId="1076"/>
          <ac:spMkLst>
            <pc:docMk/>
            <pc:sldMk cId="872520971" sldId="259"/>
            <ac:spMk id="7" creationId="{AE896DD5-BC82-3941-A4F0-07F8E3DAFD32}"/>
          </ac:spMkLst>
        </pc:spChg>
        <pc:spChg chg="add mod">
          <ac:chgData name="Qinghe Meng" userId="8ec5781b-3938-43df-a84f-730d81e9a524" providerId="ADAL" clId="{54F941C4-982E-4BD8-A72E-B5713F333B4F}" dt="2025-02-04T17:40:29.256" v="273" actId="1076"/>
          <ac:spMkLst>
            <pc:docMk/>
            <pc:sldMk cId="872520971" sldId="259"/>
            <ac:spMk id="9" creationId="{F3BB3B22-BE43-75B7-E380-645DE16A6E85}"/>
          </ac:spMkLst>
        </pc:spChg>
        <pc:spChg chg="add mod">
          <ac:chgData name="Qinghe Meng" userId="8ec5781b-3938-43df-a84f-730d81e9a524" providerId="ADAL" clId="{54F941C4-982E-4BD8-A72E-B5713F333B4F}" dt="2025-02-04T17:40:11.897" v="264" actId="1076"/>
          <ac:spMkLst>
            <pc:docMk/>
            <pc:sldMk cId="872520971" sldId="259"/>
            <ac:spMk id="12" creationId="{600C7991-EA39-5D97-70D0-DAEEB6673228}"/>
          </ac:spMkLst>
        </pc:spChg>
        <pc:spChg chg="add mod">
          <ac:chgData name="Qinghe Meng" userId="8ec5781b-3938-43df-a84f-730d81e9a524" providerId="ADAL" clId="{54F941C4-982E-4BD8-A72E-B5713F333B4F}" dt="2025-02-04T17:44:08.617" v="366" actId="1076"/>
          <ac:spMkLst>
            <pc:docMk/>
            <pc:sldMk cId="872520971" sldId="259"/>
            <ac:spMk id="14" creationId="{C5AB4ACB-FC05-F983-4970-D1D4400DF6AD}"/>
          </ac:spMkLst>
        </pc:spChg>
        <pc:spChg chg="add mod">
          <ac:chgData name="Qinghe Meng" userId="8ec5781b-3938-43df-a84f-730d81e9a524" providerId="ADAL" clId="{54F941C4-982E-4BD8-A72E-B5713F333B4F}" dt="2025-02-04T17:39:03.221" v="229" actId="1076"/>
          <ac:spMkLst>
            <pc:docMk/>
            <pc:sldMk cId="872520971" sldId="259"/>
            <ac:spMk id="16" creationId="{545DD92B-FDCC-88CC-8B12-398B4741DA4C}"/>
          </ac:spMkLst>
        </pc:spChg>
        <pc:spChg chg="add mod">
          <ac:chgData name="Qinghe Meng" userId="8ec5781b-3938-43df-a84f-730d81e9a524" providerId="ADAL" clId="{54F941C4-982E-4BD8-A72E-B5713F333B4F}" dt="2025-02-04T17:39:26.640" v="242" actId="1076"/>
          <ac:spMkLst>
            <pc:docMk/>
            <pc:sldMk cId="872520971" sldId="259"/>
            <ac:spMk id="19" creationId="{B9FDD486-AEDF-927A-E64F-7A1C3544FCEF}"/>
          </ac:spMkLst>
        </pc:spChg>
        <pc:spChg chg="add mod">
          <ac:chgData name="Qinghe Meng" userId="8ec5781b-3938-43df-a84f-730d81e9a524" providerId="ADAL" clId="{54F941C4-982E-4BD8-A72E-B5713F333B4F}" dt="2025-02-04T17:39:06.282" v="230" actId="1076"/>
          <ac:spMkLst>
            <pc:docMk/>
            <pc:sldMk cId="872520971" sldId="259"/>
            <ac:spMk id="23" creationId="{430F5A21-BDF4-3583-04F8-BAE4E6775236}"/>
          </ac:spMkLst>
        </pc:spChg>
        <pc:spChg chg="add mod">
          <ac:chgData name="Qinghe Meng" userId="8ec5781b-3938-43df-a84f-730d81e9a524" providerId="ADAL" clId="{54F941C4-982E-4BD8-A72E-B5713F333B4F}" dt="2025-02-04T17:40:51.036" v="275" actId="1076"/>
          <ac:spMkLst>
            <pc:docMk/>
            <pc:sldMk cId="872520971" sldId="259"/>
            <ac:spMk id="25" creationId="{58369DAE-8609-F305-27E7-3974D479EBAD}"/>
          </ac:spMkLst>
        </pc:spChg>
        <pc:spChg chg="add del mod">
          <ac:chgData name="Qinghe Meng" userId="8ec5781b-3938-43df-a84f-730d81e9a524" providerId="ADAL" clId="{54F941C4-982E-4BD8-A72E-B5713F333B4F}" dt="2025-02-04T17:35:41.546" v="150" actId="478"/>
          <ac:spMkLst>
            <pc:docMk/>
            <pc:sldMk cId="872520971" sldId="259"/>
            <ac:spMk id="27" creationId="{73BB27C3-F005-EEAB-0B36-1E598D94A774}"/>
          </ac:spMkLst>
        </pc:spChg>
        <pc:spChg chg="add mod">
          <ac:chgData name="Qinghe Meng" userId="8ec5781b-3938-43df-a84f-730d81e9a524" providerId="ADAL" clId="{54F941C4-982E-4BD8-A72E-B5713F333B4F}" dt="2025-02-04T17:40:53.158" v="276" actId="1076"/>
          <ac:spMkLst>
            <pc:docMk/>
            <pc:sldMk cId="872520971" sldId="259"/>
            <ac:spMk id="28" creationId="{86858C2A-D400-C343-CA22-8D3E1E93C72D}"/>
          </ac:spMkLst>
        </pc:spChg>
        <pc:spChg chg="add mod">
          <ac:chgData name="Qinghe Meng" userId="8ec5781b-3938-43df-a84f-730d81e9a524" providerId="ADAL" clId="{54F941C4-982E-4BD8-A72E-B5713F333B4F}" dt="2025-02-04T17:40:54.945" v="277" actId="1076"/>
          <ac:spMkLst>
            <pc:docMk/>
            <pc:sldMk cId="872520971" sldId="259"/>
            <ac:spMk id="29" creationId="{A5841439-6399-6A9B-50E8-78AB71B731D6}"/>
          </ac:spMkLst>
        </pc:spChg>
        <pc:spChg chg="add mod">
          <ac:chgData name="Qinghe Meng" userId="8ec5781b-3938-43df-a84f-730d81e9a524" providerId="ADAL" clId="{54F941C4-982E-4BD8-A72E-B5713F333B4F}" dt="2025-02-04T17:39:45.564" v="252" actId="1076"/>
          <ac:spMkLst>
            <pc:docMk/>
            <pc:sldMk cId="872520971" sldId="259"/>
            <ac:spMk id="30" creationId="{3794CE44-8FB9-C3C5-DF77-17F4A37524B6}"/>
          </ac:spMkLst>
        </pc:spChg>
        <pc:spChg chg="add mod">
          <ac:chgData name="Qinghe Meng" userId="8ec5781b-3938-43df-a84f-730d81e9a524" providerId="ADAL" clId="{54F941C4-982E-4BD8-A72E-B5713F333B4F}" dt="2025-02-04T17:37:25.926" v="198" actId="6549"/>
          <ac:spMkLst>
            <pc:docMk/>
            <pc:sldMk cId="872520971" sldId="259"/>
            <ac:spMk id="32" creationId="{E8DE2242-4E09-E40D-2432-F399DA8C720B}"/>
          </ac:spMkLst>
        </pc:spChg>
        <pc:spChg chg="add mod">
          <ac:chgData name="Qinghe Meng" userId="8ec5781b-3938-43df-a84f-730d81e9a524" providerId="ADAL" clId="{54F941C4-982E-4BD8-A72E-B5713F333B4F}" dt="2025-02-04T17:37:47.663" v="203" actId="1076"/>
          <ac:spMkLst>
            <pc:docMk/>
            <pc:sldMk cId="872520971" sldId="259"/>
            <ac:spMk id="33" creationId="{9CB03332-DB48-CA6F-0708-77AB6BCAC7EC}"/>
          </ac:spMkLst>
        </pc:spChg>
        <pc:spChg chg="add mod">
          <ac:chgData name="Qinghe Meng" userId="8ec5781b-3938-43df-a84f-730d81e9a524" providerId="ADAL" clId="{54F941C4-982E-4BD8-A72E-B5713F333B4F}" dt="2025-02-04T17:38:55.539" v="226" actId="1076"/>
          <ac:spMkLst>
            <pc:docMk/>
            <pc:sldMk cId="872520971" sldId="259"/>
            <ac:spMk id="34" creationId="{2DDB3820-E944-20F1-BCBF-F933A6506E94}"/>
          </ac:spMkLst>
        </pc:spChg>
        <pc:spChg chg="add mod">
          <ac:chgData name="Qinghe Meng" userId="8ec5781b-3938-43df-a84f-730d81e9a524" providerId="ADAL" clId="{54F941C4-982E-4BD8-A72E-B5713F333B4F}" dt="2025-02-04T17:40:32.581" v="274" actId="1076"/>
          <ac:spMkLst>
            <pc:docMk/>
            <pc:sldMk cId="872520971" sldId="259"/>
            <ac:spMk id="35" creationId="{DF73B5B8-64EB-FE5B-B06F-29DA65DBDCF1}"/>
          </ac:spMkLst>
        </pc:spChg>
        <pc:spChg chg="add mod">
          <ac:chgData name="Qinghe Meng" userId="8ec5781b-3938-43df-a84f-730d81e9a524" providerId="ADAL" clId="{54F941C4-982E-4BD8-A72E-B5713F333B4F}" dt="2025-02-04T17:38:30.326" v="215" actId="20577"/>
          <ac:spMkLst>
            <pc:docMk/>
            <pc:sldMk cId="872520971" sldId="259"/>
            <ac:spMk id="36" creationId="{E05F3F4D-59DA-780F-FA55-CCA89B464278}"/>
          </ac:spMkLst>
        </pc:spChg>
        <pc:picChg chg="add mod">
          <ac:chgData name="Qinghe Meng" userId="8ec5781b-3938-43df-a84f-730d81e9a524" providerId="ADAL" clId="{54F941C4-982E-4BD8-A72E-B5713F333B4F}" dt="2025-02-04T17:38:35.150" v="216" actId="1076"/>
          <ac:picMkLst>
            <pc:docMk/>
            <pc:sldMk cId="872520971" sldId="259"/>
            <ac:picMk id="3" creationId="{1F4FF6F4-5021-0D68-E9D4-69B3A9F69BC8}"/>
          </ac:picMkLst>
        </pc:picChg>
        <pc:picChg chg="mod">
          <ac:chgData name="Qinghe Meng" userId="8ec5781b-3938-43df-a84f-730d81e9a524" providerId="ADAL" clId="{54F941C4-982E-4BD8-A72E-B5713F333B4F}" dt="2025-02-04T17:37:56.723" v="207" actId="1076"/>
          <ac:picMkLst>
            <pc:docMk/>
            <pc:sldMk cId="872520971" sldId="259"/>
            <ac:picMk id="6" creationId="{5FA7248B-F67C-9375-B8EB-117D7D3AF075}"/>
          </ac:picMkLst>
        </pc:picChg>
        <pc:picChg chg="mod">
          <ac:chgData name="Qinghe Meng" userId="8ec5781b-3938-43df-a84f-730d81e9a524" providerId="ADAL" clId="{54F941C4-982E-4BD8-A72E-B5713F333B4F}" dt="2025-02-04T17:36:45.518" v="169" actId="1076"/>
          <ac:picMkLst>
            <pc:docMk/>
            <pc:sldMk cId="872520971" sldId="259"/>
            <ac:picMk id="10" creationId="{5A009302-CD20-A1CF-A151-C44EF9BE70C6}"/>
          </ac:picMkLst>
        </pc:picChg>
        <pc:picChg chg="del">
          <ac:chgData name="Qinghe Meng" userId="8ec5781b-3938-43df-a84f-730d81e9a524" providerId="ADAL" clId="{54F941C4-982E-4BD8-A72E-B5713F333B4F}" dt="2025-02-04T17:26:19.088" v="2" actId="478"/>
          <ac:picMkLst>
            <pc:docMk/>
            <pc:sldMk cId="872520971" sldId="259"/>
            <ac:picMk id="18" creationId="{66DF3ED4-64A5-880B-B12B-CC47358625F5}"/>
          </ac:picMkLst>
        </pc:picChg>
        <pc:picChg chg="mod">
          <ac:chgData name="Qinghe Meng" userId="8ec5781b-3938-43df-a84f-730d81e9a524" providerId="ADAL" clId="{54F941C4-982E-4BD8-A72E-B5713F333B4F}" dt="2025-02-04T17:39:51.707" v="254" actId="14100"/>
          <ac:picMkLst>
            <pc:docMk/>
            <pc:sldMk cId="872520971" sldId="259"/>
            <ac:picMk id="20" creationId="{F41B2151-51B8-0FFE-F6FD-95EB561D61E0}"/>
          </ac:picMkLst>
        </pc:picChg>
        <pc:picChg chg="mod">
          <ac:chgData name="Qinghe Meng" userId="8ec5781b-3938-43df-a84f-730d81e9a524" providerId="ADAL" clId="{54F941C4-982E-4BD8-A72E-B5713F333B4F}" dt="2025-02-04T17:40:13.658" v="265" actId="1076"/>
          <ac:picMkLst>
            <pc:docMk/>
            <pc:sldMk cId="872520971" sldId="259"/>
            <ac:picMk id="22" creationId="{1C87110E-50C2-4A9B-7386-3145D8348CD5}"/>
          </ac:picMkLst>
        </pc:picChg>
        <pc:picChg chg="mod">
          <ac:chgData name="Qinghe Meng" userId="8ec5781b-3938-43df-a84f-730d81e9a524" providerId="ADAL" clId="{54F941C4-982E-4BD8-A72E-B5713F333B4F}" dt="2025-02-04T17:39:12.377" v="234" actId="1076"/>
          <ac:picMkLst>
            <pc:docMk/>
            <pc:sldMk cId="872520971" sldId="259"/>
            <ac:picMk id="24" creationId="{14728815-C021-6AB5-2143-9C592D863C42}"/>
          </ac:picMkLst>
        </pc:picChg>
        <pc:picChg chg="mod">
          <ac:chgData name="Qinghe Meng" userId="8ec5781b-3938-43df-a84f-730d81e9a524" providerId="ADAL" clId="{54F941C4-982E-4BD8-A72E-B5713F333B4F}" dt="2025-02-04T17:39:29.044" v="243" actId="1076"/>
          <ac:picMkLst>
            <pc:docMk/>
            <pc:sldMk cId="872520971" sldId="259"/>
            <ac:picMk id="26" creationId="{E61E4FBB-1231-7A9D-5DD4-7D22EE7BA1FE}"/>
          </ac:picMkLst>
        </pc:picChg>
        <pc:picChg chg="mod">
          <ac:chgData name="Qinghe Meng" userId="8ec5781b-3938-43df-a84f-730d81e9a524" providerId="ADAL" clId="{54F941C4-982E-4BD8-A72E-B5713F333B4F}" dt="2025-02-04T17:38:52.865" v="225" actId="1076"/>
          <ac:picMkLst>
            <pc:docMk/>
            <pc:sldMk cId="872520971" sldId="259"/>
            <ac:picMk id="31" creationId="{AA1D94D1-BB51-DE58-2152-0BA57BD5F2AC}"/>
          </ac:picMkLst>
        </pc:picChg>
        <pc:cxnChg chg="add mod">
          <ac:chgData name="Qinghe Meng" userId="8ec5781b-3938-43df-a84f-730d81e9a524" providerId="ADAL" clId="{54F941C4-982E-4BD8-A72E-B5713F333B4F}" dt="2025-02-04T17:33:43.498" v="103"/>
          <ac:cxnSpMkLst>
            <pc:docMk/>
            <pc:sldMk cId="872520971" sldId="259"/>
            <ac:cxnSpMk id="5" creationId="{981E6934-E147-32F2-1D20-0DF9D7DC0C58}"/>
          </ac:cxnSpMkLst>
        </pc:cxnChg>
        <pc:cxnChg chg="add mod">
          <ac:chgData name="Qinghe Meng" userId="8ec5781b-3938-43df-a84f-730d81e9a524" providerId="ADAL" clId="{54F941C4-982E-4BD8-A72E-B5713F333B4F}" dt="2025-02-04T17:39:33.337" v="245" actId="1076"/>
          <ac:cxnSpMkLst>
            <pc:docMk/>
            <pc:sldMk cId="872520971" sldId="259"/>
            <ac:cxnSpMk id="8" creationId="{54EEBBC6-CD1D-A2AA-0F86-508E80C3A07F}"/>
          </ac:cxnSpMkLst>
        </pc:cxnChg>
        <pc:cxnChg chg="add mod">
          <ac:chgData name="Qinghe Meng" userId="8ec5781b-3938-43df-a84f-730d81e9a524" providerId="ADAL" clId="{54F941C4-982E-4BD8-A72E-B5713F333B4F}" dt="2025-02-04T17:39:18.224" v="236" actId="1076"/>
          <ac:cxnSpMkLst>
            <pc:docMk/>
            <pc:sldMk cId="872520971" sldId="259"/>
            <ac:cxnSpMk id="11" creationId="{A9E89E12-FF46-ED38-D945-37DE468E74AD}"/>
          </ac:cxnSpMkLst>
        </pc:cxnChg>
        <pc:cxnChg chg="add mod">
          <ac:chgData name="Qinghe Meng" userId="8ec5781b-3938-43df-a84f-730d81e9a524" providerId="ADAL" clId="{54F941C4-982E-4BD8-A72E-B5713F333B4F}" dt="2025-02-04T17:38:59.345" v="228" actId="1076"/>
          <ac:cxnSpMkLst>
            <pc:docMk/>
            <pc:sldMk cId="872520971" sldId="259"/>
            <ac:cxnSpMk id="13" creationId="{F60FA643-AC59-5D68-99A8-EB3DD8FA242E}"/>
          </ac:cxnSpMkLst>
        </pc:cxnChg>
        <pc:cxnChg chg="add mod">
          <ac:chgData name="Qinghe Meng" userId="8ec5781b-3938-43df-a84f-730d81e9a524" providerId="ADAL" clId="{54F941C4-982E-4BD8-A72E-B5713F333B4F}" dt="2025-02-04T17:38:37.872" v="217" actId="1076"/>
          <ac:cxnSpMkLst>
            <pc:docMk/>
            <pc:sldMk cId="872520971" sldId="259"/>
            <ac:cxnSpMk id="15" creationId="{E6C60176-B9BA-D799-3662-545733196B40}"/>
          </ac:cxnSpMkLst>
        </pc:cxnChg>
        <pc:cxnChg chg="add mod">
          <ac:chgData name="Qinghe Meng" userId="8ec5781b-3938-43df-a84f-730d81e9a524" providerId="ADAL" clId="{54F941C4-982E-4BD8-A72E-B5713F333B4F}" dt="2025-02-04T17:38:01.490" v="208" actId="1076"/>
          <ac:cxnSpMkLst>
            <pc:docMk/>
            <pc:sldMk cId="872520971" sldId="259"/>
            <ac:cxnSpMk id="17" creationId="{8ADB3B33-8636-99E7-BA21-26FE41A95F49}"/>
          </ac:cxnSpMkLst>
        </pc:cxnChg>
        <pc:cxnChg chg="add mod">
          <ac:chgData name="Qinghe Meng" userId="8ec5781b-3938-43df-a84f-730d81e9a524" providerId="ADAL" clId="{54F941C4-982E-4BD8-A72E-B5713F333B4F}" dt="2025-02-04T17:37:04.154" v="177" actId="1076"/>
          <ac:cxnSpMkLst>
            <pc:docMk/>
            <pc:sldMk cId="872520971" sldId="259"/>
            <ac:cxnSpMk id="21" creationId="{8CBB48FA-9777-D92F-5F3F-1180961699AA}"/>
          </ac:cxnSpMkLst>
        </pc:cxnChg>
        <pc:cxnChg chg="add mod">
          <ac:chgData name="Qinghe Meng" userId="8ec5781b-3938-43df-a84f-730d81e9a524" providerId="ADAL" clId="{54F941C4-982E-4BD8-A72E-B5713F333B4F}" dt="2025-02-04T17:40:18.248" v="266" actId="1076"/>
          <ac:cxnSpMkLst>
            <pc:docMk/>
            <pc:sldMk cId="872520971" sldId="259"/>
            <ac:cxnSpMk id="37" creationId="{1B2D2EC1-A25E-E056-4976-4E94EFB0CA1E}"/>
          </ac:cxnSpMkLst>
        </pc:cxnChg>
        <pc:cxnChg chg="add mod">
          <ac:chgData name="Qinghe Meng" userId="8ec5781b-3938-43df-a84f-730d81e9a524" providerId="ADAL" clId="{54F941C4-982E-4BD8-A72E-B5713F333B4F}" dt="2025-02-04T17:40:04.332" v="258" actId="1076"/>
          <ac:cxnSpMkLst>
            <pc:docMk/>
            <pc:sldMk cId="872520971" sldId="259"/>
            <ac:cxnSpMk id="38" creationId="{AC27A54E-CA04-2EE6-2325-58B9D702A9E4}"/>
          </ac:cxnSpMkLst>
        </pc:cxnChg>
      </pc:sldChg>
      <pc:sldChg chg="addSp delSp modSp mod">
        <pc:chgData name="Qinghe Meng" userId="8ec5781b-3938-43df-a84f-730d81e9a524" providerId="ADAL" clId="{54F941C4-982E-4BD8-A72E-B5713F333B4F}" dt="2025-02-04T17:46:52.757" v="425" actId="1076"/>
        <pc:sldMkLst>
          <pc:docMk/>
          <pc:sldMk cId="3570030596" sldId="260"/>
        </pc:sldMkLst>
        <pc:spChg chg="add mod">
          <ac:chgData name="Qinghe Meng" userId="8ec5781b-3938-43df-a84f-730d81e9a524" providerId="ADAL" clId="{54F941C4-982E-4BD8-A72E-B5713F333B4F}" dt="2025-02-04T17:42:40.100" v="326" actId="6549"/>
          <ac:spMkLst>
            <pc:docMk/>
            <pc:sldMk cId="3570030596" sldId="260"/>
            <ac:spMk id="2" creationId="{B1CA8FE1-DDAE-7EEF-4FC5-CD5072597B0D}"/>
          </ac:spMkLst>
        </pc:spChg>
        <pc:spChg chg="add mod">
          <ac:chgData name="Qinghe Meng" userId="8ec5781b-3938-43df-a84f-730d81e9a524" providerId="ADAL" clId="{54F941C4-982E-4BD8-A72E-B5713F333B4F}" dt="2025-02-04T17:45:42.042" v="396" actId="1076"/>
          <ac:spMkLst>
            <pc:docMk/>
            <pc:sldMk cId="3570030596" sldId="260"/>
            <ac:spMk id="3" creationId="{FE105411-2FCE-8C26-E8D2-B6F55C383B99}"/>
          </ac:spMkLst>
        </pc:spChg>
        <pc:spChg chg="del mod">
          <ac:chgData name="Qinghe Meng" userId="8ec5781b-3938-43df-a84f-730d81e9a524" providerId="ADAL" clId="{54F941C4-982E-4BD8-A72E-B5713F333B4F}" dt="2025-02-04T17:42:27.540" v="309" actId="478"/>
          <ac:spMkLst>
            <pc:docMk/>
            <pc:sldMk cId="3570030596" sldId="260"/>
            <ac:spMk id="4" creationId="{FDF6E585-0F62-AF9C-4400-19202098E954}"/>
          </ac:spMkLst>
        </pc:spChg>
        <pc:spChg chg="add mod">
          <ac:chgData name="Qinghe Meng" userId="8ec5781b-3938-43df-a84f-730d81e9a524" providerId="ADAL" clId="{54F941C4-982E-4BD8-A72E-B5713F333B4F}" dt="2025-02-04T17:46:52.757" v="425" actId="1076"/>
          <ac:spMkLst>
            <pc:docMk/>
            <pc:sldMk cId="3570030596" sldId="260"/>
            <ac:spMk id="5" creationId="{2ED7DFCB-473B-245A-2775-9D2B2C8D7504}"/>
          </ac:spMkLst>
        </pc:spChg>
        <pc:spChg chg="add mod">
          <ac:chgData name="Qinghe Meng" userId="8ec5781b-3938-43df-a84f-730d81e9a524" providerId="ADAL" clId="{54F941C4-982E-4BD8-A72E-B5713F333B4F}" dt="2025-02-04T17:46:10.557" v="407" actId="1076"/>
          <ac:spMkLst>
            <pc:docMk/>
            <pc:sldMk cId="3570030596" sldId="260"/>
            <ac:spMk id="6" creationId="{86A1171C-E21B-94A7-65F1-014E796647CD}"/>
          </ac:spMkLst>
        </pc:spChg>
        <pc:spChg chg="add mod">
          <ac:chgData name="Qinghe Meng" userId="8ec5781b-3938-43df-a84f-730d81e9a524" providerId="ADAL" clId="{54F941C4-982E-4BD8-A72E-B5713F333B4F}" dt="2025-02-04T17:45:44.316" v="397" actId="1076"/>
          <ac:spMkLst>
            <pc:docMk/>
            <pc:sldMk cId="3570030596" sldId="260"/>
            <ac:spMk id="7" creationId="{3691A478-918F-EB90-A106-6F2872247559}"/>
          </ac:spMkLst>
        </pc:spChg>
        <pc:spChg chg="add mod">
          <ac:chgData name="Qinghe Meng" userId="8ec5781b-3938-43df-a84f-730d81e9a524" providerId="ADAL" clId="{54F941C4-982E-4BD8-A72E-B5713F333B4F}" dt="2025-02-04T17:45:19.916" v="388" actId="1076"/>
          <ac:spMkLst>
            <pc:docMk/>
            <pc:sldMk cId="3570030596" sldId="260"/>
            <ac:spMk id="8" creationId="{13457790-2319-698E-B2A1-25758111C6CC}"/>
          </ac:spMkLst>
        </pc:spChg>
        <pc:spChg chg="add mod">
          <ac:chgData name="Qinghe Meng" userId="8ec5781b-3938-43df-a84f-730d81e9a524" providerId="ADAL" clId="{54F941C4-982E-4BD8-A72E-B5713F333B4F}" dt="2025-02-04T17:46:28.614" v="415" actId="1076"/>
          <ac:spMkLst>
            <pc:docMk/>
            <pc:sldMk cId="3570030596" sldId="260"/>
            <ac:spMk id="9" creationId="{ABC0E59A-05AD-C616-45F2-0340A58C3579}"/>
          </ac:spMkLst>
        </pc:spChg>
        <pc:spChg chg="add mod">
          <ac:chgData name="Qinghe Meng" userId="8ec5781b-3938-43df-a84f-730d81e9a524" providerId="ADAL" clId="{54F941C4-982E-4BD8-A72E-B5713F333B4F}" dt="2025-02-04T17:45:26.566" v="391" actId="1076"/>
          <ac:spMkLst>
            <pc:docMk/>
            <pc:sldMk cId="3570030596" sldId="260"/>
            <ac:spMk id="11" creationId="{1FF1F6F3-9265-FD8F-2F08-2DE3F38A3344}"/>
          </ac:spMkLst>
        </pc:spChg>
        <pc:spChg chg="add mod">
          <ac:chgData name="Qinghe Meng" userId="8ec5781b-3938-43df-a84f-730d81e9a524" providerId="ADAL" clId="{54F941C4-982E-4BD8-A72E-B5713F333B4F}" dt="2025-02-04T17:46:31.298" v="416" actId="1076"/>
          <ac:spMkLst>
            <pc:docMk/>
            <pc:sldMk cId="3570030596" sldId="260"/>
            <ac:spMk id="12" creationId="{8D21EB27-EE3B-F449-2618-4F1BB8B5648C}"/>
          </ac:spMkLst>
        </pc:spChg>
        <pc:spChg chg="add mod">
          <ac:chgData name="Qinghe Meng" userId="8ec5781b-3938-43df-a84f-730d81e9a524" providerId="ADAL" clId="{54F941C4-982E-4BD8-A72E-B5713F333B4F}" dt="2025-02-04T17:45:18.081" v="387" actId="1076"/>
          <ac:spMkLst>
            <pc:docMk/>
            <pc:sldMk cId="3570030596" sldId="260"/>
            <ac:spMk id="13" creationId="{1F0F5CAA-06F6-84B5-7FD4-A9CFA6CACA0D}"/>
          </ac:spMkLst>
        </pc:spChg>
        <pc:spChg chg="add mod">
          <ac:chgData name="Qinghe Meng" userId="8ec5781b-3938-43df-a84f-730d81e9a524" providerId="ADAL" clId="{54F941C4-982E-4BD8-A72E-B5713F333B4F}" dt="2025-02-04T17:46:25.402" v="414" actId="1076"/>
          <ac:spMkLst>
            <pc:docMk/>
            <pc:sldMk cId="3570030596" sldId="260"/>
            <ac:spMk id="16" creationId="{A07878BB-B6F1-4EFF-1143-6190FC9D0F6E}"/>
          </ac:spMkLst>
        </pc:spChg>
        <pc:spChg chg="add mod">
          <ac:chgData name="Qinghe Meng" userId="8ec5781b-3938-43df-a84f-730d81e9a524" providerId="ADAL" clId="{54F941C4-982E-4BD8-A72E-B5713F333B4F}" dt="2025-02-04T17:46:19.338" v="411" actId="1076"/>
          <ac:spMkLst>
            <pc:docMk/>
            <pc:sldMk cId="3570030596" sldId="260"/>
            <ac:spMk id="19" creationId="{6A658762-6ED0-2009-431F-0836AC0A11B6}"/>
          </ac:spMkLst>
        </pc:spChg>
        <pc:spChg chg="add mod">
          <ac:chgData name="Qinghe Meng" userId="8ec5781b-3938-43df-a84f-730d81e9a524" providerId="ADAL" clId="{54F941C4-982E-4BD8-A72E-B5713F333B4F}" dt="2025-02-04T17:46:04.560" v="404" actId="1076"/>
          <ac:spMkLst>
            <pc:docMk/>
            <pc:sldMk cId="3570030596" sldId="260"/>
            <ac:spMk id="23" creationId="{92AAD4FA-EA77-E0D9-5111-C76E93735BD7}"/>
          </ac:spMkLst>
        </pc:spChg>
        <pc:spChg chg="add mod">
          <ac:chgData name="Qinghe Meng" userId="8ec5781b-3938-43df-a84f-730d81e9a524" providerId="ADAL" clId="{54F941C4-982E-4BD8-A72E-B5713F333B4F}" dt="2025-02-04T17:45:36.946" v="394" actId="1076"/>
          <ac:spMkLst>
            <pc:docMk/>
            <pc:sldMk cId="3570030596" sldId="260"/>
            <ac:spMk id="27" creationId="{39A28CA4-C52A-E874-7DC5-88BB3373482A}"/>
          </ac:spMkLst>
        </pc:spChg>
        <pc:spChg chg="add mod">
          <ac:chgData name="Qinghe Meng" userId="8ec5781b-3938-43df-a84f-730d81e9a524" providerId="ADAL" clId="{54F941C4-982E-4BD8-A72E-B5713F333B4F}" dt="2025-02-04T17:45:55.483" v="401" actId="1076"/>
          <ac:spMkLst>
            <pc:docMk/>
            <pc:sldMk cId="3570030596" sldId="260"/>
            <ac:spMk id="29" creationId="{8FEA544A-113B-48DF-51E4-8A4766867532}"/>
          </ac:spMkLst>
        </pc:spChg>
        <pc:spChg chg="add mod">
          <ac:chgData name="Qinghe Meng" userId="8ec5781b-3938-43df-a84f-730d81e9a524" providerId="ADAL" clId="{54F941C4-982E-4BD8-A72E-B5713F333B4F}" dt="2025-02-04T17:46:39.099" v="419" actId="1076"/>
          <ac:spMkLst>
            <pc:docMk/>
            <pc:sldMk cId="3570030596" sldId="260"/>
            <ac:spMk id="31" creationId="{32E5CDC1-B48F-0511-2E43-1E1C414885A0}"/>
          </ac:spMkLst>
        </pc:spChg>
        <pc:spChg chg="add mod">
          <ac:chgData name="Qinghe Meng" userId="8ec5781b-3938-43df-a84f-730d81e9a524" providerId="ADAL" clId="{54F941C4-982E-4BD8-A72E-B5713F333B4F}" dt="2025-02-04T17:46:48.873" v="423" actId="1076"/>
          <ac:spMkLst>
            <pc:docMk/>
            <pc:sldMk cId="3570030596" sldId="260"/>
            <ac:spMk id="33" creationId="{1C20A9BD-F13C-07EE-A751-3691A05B8F0D}"/>
          </ac:spMkLst>
        </pc:spChg>
        <pc:picChg chg="mod">
          <ac:chgData name="Qinghe Meng" userId="8ec5781b-3938-43df-a84f-730d81e9a524" providerId="ADAL" clId="{54F941C4-982E-4BD8-A72E-B5713F333B4F}" dt="2025-02-04T17:45:14.926" v="386" actId="1076"/>
          <ac:picMkLst>
            <pc:docMk/>
            <pc:sldMk cId="3570030596" sldId="260"/>
            <ac:picMk id="10" creationId="{4CC6BEF4-4119-D39A-51FC-5AD37FC3138E}"/>
          </ac:picMkLst>
        </pc:picChg>
        <pc:picChg chg="mod">
          <ac:chgData name="Qinghe Meng" userId="8ec5781b-3938-43df-a84f-730d81e9a524" providerId="ADAL" clId="{54F941C4-982E-4BD8-A72E-B5713F333B4F}" dt="2025-02-04T17:45:48.578" v="399" actId="1076"/>
          <ac:picMkLst>
            <pc:docMk/>
            <pc:sldMk cId="3570030596" sldId="260"/>
            <ac:picMk id="14" creationId="{7A5A20AB-9B02-6842-4163-134D7C3776F4}"/>
          </ac:picMkLst>
        </pc:picChg>
        <pc:picChg chg="mod">
          <ac:chgData name="Qinghe Meng" userId="8ec5781b-3938-43df-a84f-730d81e9a524" providerId="ADAL" clId="{54F941C4-982E-4BD8-A72E-B5713F333B4F}" dt="2025-02-04T17:45:39.950" v="395" actId="1076"/>
          <ac:picMkLst>
            <pc:docMk/>
            <pc:sldMk cId="3570030596" sldId="260"/>
            <ac:picMk id="18" creationId="{230F42B9-45FE-0473-D6D0-CBBFECE3F259}"/>
          </ac:picMkLst>
        </pc:picChg>
        <pc:picChg chg="mod">
          <ac:chgData name="Qinghe Meng" userId="8ec5781b-3938-43df-a84f-730d81e9a524" providerId="ADAL" clId="{54F941C4-982E-4BD8-A72E-B5713F333B4F}" dt="2025-02-04T17:45:28.728" v="392" actId="1076"/>
          <ac:picMkLst>
            <pc:docMk/>
            <pc:sldMk cId="3570030596" sldId="260"/>
            <ac:picMk id="20" creationId="{0D9D623E-5DEE-8D7B-40FC-AE1F78E65C2F}"/>
          </ac:picMkLst>
        </pc:picChg>
        <pc:picChg chg="mod">
          <ac:chgData name="Qinghe Meng" userId="8ec5781b-3938-43df-a84f-730d81e9a524" providerId="ADAL" clId="{54F941C4-982E-4BD8-A72E-B5713F333B4F}" dt="2025-02-04T17:46:42.985" v="421" actId="1076"/>
          <ac:picMkLst>
            <pc:docMk/>
            <pc:sldMk cId="3570030596" sldId="260"/>
            <ac:picMk id="22" creationId="{A6DA3F8D-AE05-2304-6D9E-B0764F08CBAD}"/>
          </ac:picMkLst>
        </pc:picChg>
        <pc:picChg chg="mod">
          <ac:chgData name="Qinghe Meng" userId="8ec5781b-3938-43df-a84f-730d81e9a524" providerId="ADAL" clId="{54F941C4-982E-4BD8-A72E-B5713F333B4F}" dt="2025-02-04T17:46:32.491" v="417" actId="1076"/>
          <ac:picMkLst>
            <pc:docMk/>
            <pc:sldMk cId="3570030596" sldId="260"/>
            <ac:picMk id="24" creationId="{354427DE-78E7-1640-A162-6332A0590E0C}"/>
          </ac:picMkLst>
        </pc:picChg>
        <pc:picChg chg="mod">
          <ac:chgData name="Qinghe Meng" userId="8ec5781b-3938-43df-a84f-730d81e9a524" providerId="ADAL" clId="{54F941C4-982E-4BD8-A72E-B5713F333B4F}" dt="2025-02-04T17:46:11.383" v="408" actId="1076"/>
          <ac:picMkLst>
            <pc:docMk/>
            <pc:sldMk cId="3570030596" sldId="260"/>
            <ac:picMk id="26" creationId="{9D2C8985-6B08-F976-86B1-F790789F8911}"/>
          </ac:picMkLst>
        </pc:picChg>
        <pc:picChg chg="mod">
          <ac:chgData name="Qinghe Meng" userId="8ec5781b-3938-43df-a84f-730d81e9a524" providerId="ADAL" clId="{54F941C4-982E-4BD8-A72E-B5713F333B4F}" dt="2025-02-04T17:46:50.257" v="424" actId="1076"/>
          <ac:picMkLst>
            <pc:docMk/>
            <pc:sldMk cId="3570030596" sldId="260"/>
            <ac:picMk id="34" creationId="{0132B54B-D830-C9BB-FF2C-06E54C7C542B}"/>
          </ac:picMkLst>
        </pc:picChg>
        <pc:cxnChg chg="add mod">
          <ac:chgData name="Qinghe Meng" userId="8ec5781b-3938-43df-a84f-730d81e9a524" providerId="ADAL" clId="{54F941C4-982E-4BD8-A72E-B5713F333B4F}" dt="2025-02-04T17:45:10.056" v="384" actId="1076"/>
          <ac:cxnSpMkLst>
            <pc:docMk/>
            <pc:sldMk cId="3570030596" sldId="260"/>
            <ac:cxnSpMk id="15" creationId="{D67E4FE6-4D43-670E-D7A1-3CB24C244687}"/>
          </ac:cxnSpMkLst>
        </pc:cxnChg>
        <pc:cxnChg chg="add mod">
          <ac:chgData name="Qinghe Meng" userId="8ec5781b-3938-43df-a84f-730d81e9a524" providerId="ADAL" clId="{54F941C4-982E-4BD8-A72E-B5713F333B4F}" dt="2025-02-04T17:46:23.231" v="413" actId="1076"/>
          <ac:cxnSpMkLst>
            <pc:docMk/>
            <pc:sldMk cId="3570030596" sldId="260"/>
            <ac:cxnSpMk id="17" creationId="{8096C5B6-19F8-2EE3-02A9-D18527EE319C}"/>
          </ac:cxnSpMkLst>
        </pc:cxnChg>
        <pc:cxnChg chg="add mod">
          <ac:chgData name="Qinghe Meng" userId="8ec5781b-3938-43df-a84f-730d81e9a524" providerId="ADAL" clId="{54F941C4-982E-4BD8-A72E-B5713F333B4F}" dt="2025-02-04T17:46:17.184" v="410" actId="1076"/>
          <ac:cxnSpMkLst>
            <pc:docMk/>
            <pc:sldMk cId="3570030596" sldId="260"/>
            <ac:cxnSpMk id="21" creationId="{947BA7F9-1163-897E-1356-CB8719CFC1F0}"/>
          </ac:cxnSpMkLst>
        </pc:cxnChg>
        <pc:cxnChg chg="add mod">
          <ac:chgData name="Qinghe Meng" userId="8ec5781b-3938-43df-a84f-730d81e9a524" providerId="ADAL" clId="{54F941C4-982E-4BD8-A72E-B5713F333B4F}" dt="2025-02-04T17:46:01.860" v="403" actId="1076"/>
          <ac:cxnSpMkLst>
            <pc:docMk/>
            <pc:sldMk cId="3570030596" sldId="260"/>
            <ac:cxnSpMk id="25" creationId="{CA0FFC2E-85A4-461D-629A-9620B5619662}"/>
          </ac:cxnSpMkLst>
        </pc:cxnChg>
        <pc:cxnChg chg="add mod">
          <ac:chgData name="Qinghe Meng" userId="8ec5781b-3938-43df-a84f-730d81e9a524" providerId="ADAL" clId="{54F941C4-982E-4BD8-A72E-B5713F333B4F}" dt="2025-02-04T17:45:32.461" v="393" actId="1076"/>
          <ac:cxnSpMkLst>
            <pc:docMk/>
            <pc:sldMk cId="3570030596" sldId="260"/>
            <ac:cxnSpMk id="28" creationId="{75788DB5-0F44-D29F-46A2-1E2B5D64527A}"/>
          </ac:cxnSpMkLst>
        </pc:cxnChg>
        <pc:cxnChg chg="add mod">
          <ac:chgData name="Qinghe Meng" userId="8ec5781b-3938-43df-a84f-730d81e9a524" providerId="ADAL" clId="{54F941C4-982E-4BD8-A72E-B5713F333B4F}" dt="2025-02-04T17:45:51.021" v="400" actId="1076"/>
          <ac:cxnSpMkLst>
            <pc:docMk/>
            <pc:sldMk cId="3570030596" sldId="260"/>
            <ac:cxnSpMk id="30" creationId="{74D6F67B-B755-DDCF-3E59-8240EDF7B14C}"/>
          </ac:cxnSpMkLst>
        </pc:cxnChg>
        <pc:cxnChg chg="add mod">
          <ac:chgData name="Qinghe Meng" userId="8ec5781b-3938-43df-a84f-730d81e9a524" providerId="ADAL" clId="{54F941C4-982E-4BD8-A72E-B5713F333B4F}" dt="2025-02-04T17:46:36.062" v="418" actId="1076"/>
          <ac:cxnSpMkLst>
            <pc:docMk/>
            <pc:sldMk cId="3570030596" sldId="260"/>
            <ac:cxnSpMk id="32" creationId="{B2A58877-A53D-200B-319E-0C6C375CBCC4}"/>
          </ac:cxnSpMkLst>
        </pc:cxnChg>
        <pc:cxnChg chg="add mod">
          <ac:chgData name="Qinghe Meng" userId="8ec5781b-3938-43df-a84f-730d81e9a524" providerId="ADAL" clId="{54F941C4-982E-4BD8-A72E-B5713F333B4F}" dt="2025-02-04T17:46:45.554" v="422" actId="1076"/>
          <ac:cxnSpMkLst>
            <pc:docMk/>
            <pc:sldMk cId="3570030596" sldId="260"/>
            <ac:cxnSpMk id="35" creationId="{223DC2C0-0D8A-FE07-05BA-276D842C4826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EA7045-E831-188E-E8D1-3F356DEF021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ADA100A-DBBD-20F2-3282-8A1367DBBB7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F1227A-421C-6268-A46B-2A3F22A91D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B7C10-A918-4E23-A5AA-BCF7262CA536}" type="datetimeFigureOut">
              <a:rPr lang="en-US" smtClean="0"/>
              <a:t>2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0F36DB-78E3-8418-BC1A-1027F49AED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1E7E4B-114D-AE64-F0FD-F285B3D636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D451C-AA69-469D-A1AB-C75F3ADD3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66239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2B58C0-3AE8-0816-92F0-C70C2762F7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0C73F50-870E-2FE0-2E97-4F777862DD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9CCA39C-E35A-70AD-B4E1-EEC09FE3D6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B7C10-A918-4E23-A5AA-BCF7262CA536}" type="datetimeFigureOut">
              <a:rPr lang="en-US" smtClean="0"/>
              <a:t>2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7789C37-F141-EF18-4ACF-2E36DA398B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EE029D-5B59-03B3-9198-F6D74AA17A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D451C-AA69-469D-A1AB-C75F3ADD3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19407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55FAA1A-C8C5-D5BD-A04B-DE57073562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240D8E7-0A7C-456E-B1D3-A822C36873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000199-6B44-95CD-996C-672BF18CC0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B7C10-A918-4E23-A5AA-BCF7262CA536}" type="datetimeFigureOut">
              <a:rPr lang="en-US" smtClean="0"/>
              <a:t>2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7EF05C-FD4C-635F-F78E-DCEA6E02F8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AB69BC6-5849-1B95-928B-13CD03C4B7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D451C-AA69-469D-A1AB-C75F3ADD3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7140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B08262-D68F-3F65-E765-9CC167FC1D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754BF0-D1FB-15FB-FA2F-096468EC65F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B4DB8C-E44B-43E4-D26B-AEB777A53C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B7C10-A918-4E23-A5AA-BCF7262CA536}" type="datetimeFigureOut">
              <a:rPr lang="en-US" smtClean="0"/>
              <a:t>2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F1DA13-AB41-894A-95A1-F942374AF2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C68BF0-12C1-7470-E576-EF0E7D0B91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D451C-AA69-469D-A1AB-C75F3ADD3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2940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7A449E-3F17-1943-757E-A3E515C9BE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8FDDB24-7CE9-9148-2227-163F17441B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3A120D-C007-D8FE-4A56-B253A7BDE4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B7C10-A918-4E23-A5AA-BCF7262CA536}" type="datetimeFigureOut">
              <a:rPr lang="en-US" smtClean="0"/>
              <a:t>2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B1812C-A5F4-EFB6-5647-4325C99D88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3C0B07D-323E-3750-1955-00455713B0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D451C-AA69-469D-A1AB-C75F3ADD3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936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EEA404-2E0D-B0B8-4064-18D039F2E3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7F722C-5792-98D5-7156-15F56A1B402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251C2B3-609E-C4C4-E14E-276DE111C9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BE2E13-5BD9-149B-BA04-1C9FED500B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B7C10-A918-4E23-A5AA-BCF7262CA536}" type="datetimeFigureOut">
              <a:rPr lang="en-US" smtClean="0"/>
              <a:t>2/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3403A70-DE77-2610-D983-4003BB22B9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5248786-1A5E-C5DE-98B6-1B2821C7A9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D451C-AA69-469D-A1AB-C75F3ADD3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02394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AB47F7-7CF5-9C5E-A25D-F4F2237B92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83E9BE2-1F27-9997-BAD8-6FC5B8FC1B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B45CE50-1098-C451-8DCB-891FD78B23B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FFB30BA-5B83-C86C-74AD-23222646736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7CA0E5C-5F6F-2440-38EC-49189DECFD1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B962B46-88FB-1C5E-489E-8EDE27B959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B7C10-A918-4E23-A5AA-BCF7262CA536}" type="datetimeFigureOut">
              <a:rPr lang="en-US" smtClean="0"/>
              <a:t>2/4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36D1EDE-C604-639E-B5E9-0BB76D914F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90CAA1D-B2AC-28BC-61FE-6C16706FD1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D451C-AA69-469D-A1AB-C75F3ADD3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19424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CBD3FB-B0DD-5C8E-1E27-D03F054B03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E58B4D5-F0DB-8935-DDB9-B4B086648F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B7C10-A918-4E23-A5AA-BCF7262CA536}" type="datetimeFigureOut">
              <a:rPr lang="en-US" smtClean="0"/>
              <a:t>2/4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0C0DFA7-CFD1-3096-2720-897BB99B61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0694C7B-5D28-BC05-8791-6A56DC4A90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D451C-AA69-469D-A1AB-C75F3ADD3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81196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6A64BFD-5ECF-A149-E97E-C5DE5C41AE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B7C10-A918-4E23-A5AA-BCF7262CA536}" type="datetimeFigureOut">
              <a:rPr lang="en-US" smtClean="0"/>
              <a:t>2/4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1913CCC-9BE5-AAB9-58E1-56B7E55DF5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F7CA2FC-EF21-BDCC-71E8-B0D584B3E4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D451C-AA69-469D-A1AB-C75F3ADD3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32044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4DA23B-E8AD-CF57-8265-FEBBF10431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A2B13E-B113-A88E-F3B6-7B3B6DB17B6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DF542F9-12EA-3522-5686-E8514E7DEE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425EC1-BCD2-9D77-14D5-1AEF82F7CA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B7C10-A918-4E23-A5AA-BCF7262CA536}" type="datetimeFigureOut">
              <a:rPr lang="en-US" smtClean="0"/>
              <a:t>2/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0EB970-38FB-C631-235E-0418039B21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BD84E25-2750-8D76-7FC9-BB0F2CD226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D451C-AA69-469D-A1AB-C75F3ADD3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69562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2E7245-3658-0EB7-B29A-606C023426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227A830-5315-655D-239B-0FE4F60618E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2BB1897-9A5D-45AD-4CD2-84EC8B4E4B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CF4AF1-4A7A-D73D-90FB-74176BB97B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8B7C10-A918-4E23-A5AA-BCF7262CA536}" type="datetimeFigureOut">
              <a:rPr lang="en-US" smtClean="0"/>
              <a:t>2/4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8E5F25C-9411-438B-29EC-D4D03073E0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0D8E86-02BD-4D6B-BEE6-D03835A7E5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ED451C-AA69-469D-A1AB-C75F3ADD3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34915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B768996-AC04-9424-CB15-26D96F9CB8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44394F-234A-C77E-6410-346CDB51FC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E12D33-BE09-5ED0-96B6-301ED9B3937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38B7C10-A918-4E23-A5AA-BCF7262CA536}" type="datetimeFigureOut">
              <a:rPr lang="en-US" smtClean="0"/>
              <a:t>2/4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FA8FC6-3414-F31D-E90A-748962ADBD4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4A7F3A-F5BA-CC4A-DB0A-CF5C348EB18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0ED451C-AA69-469D-A1AB-C75F3ADD352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54318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jpg"/><Relationship Id="rId7" Type="http://schemas.openxmlformats.org/officeDocument/2006/relationships/image" Target="../media/image6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jpg"/><Relationship Id="rId9" Type="http://schemas.openxmlformats.org/officeDocument/2006/relationships/image" Target="../media/image16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1.png"/><Relationship Id="rId5" Type="http://schemas.openxmlformats.org/officeDocument/2006/relationships/image" Target="../media/image20.png"/><Relationship Id="rId10" Type="http://schemas.microsoft.com/office/2007/relationships/hdphoto" Target="../media/hdphoto1.wdp"/><Relationship Id="rId4" Type="http://schemas.openxmlformats.org/officeDocument/2006/relationships/image" Target="../media/image19.png"/><Relationship Id="rId9" Type="http://schemas.openxmlformats.org/officeDocument/2006/relationships/image" Target="../media/image24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png"/><Relationship Id="rId13" Type="http://schemas.openxmlformats.org/officeDocument/2006/relationships/image" Target="../media/image36.png"/><Relationship Id="rId3" Type="http://schemas.openxmlformats.org/officeDocument/2006/relationships/image" Target="../media/image26.png"/><Relationship Id="rId7" Type="http://schemas.openxmlformats.org/officeDocument/2006/relationships/image" Target="../media/image30.png"/><Relationship Id="rId12" Type="http://schemas.openxmlformats.org/officeDocument/2006/relationships/image" Target="../media/image35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9.png"/><Relationship Id="rId11" Type="http://schemas.openxmlformats.org/officeDocument/2006/relationships/image" Target="../media/image34.png"/><Relationship Id="rId5" Type="http://schemas.openxmlformats.org/officeDocument/2006/relationships/image" Target="../media/image28.png"/><Relationship Id="rId10" Type="http://schemas.openxmlformats.org/officeDocument/2006/relationships/image" Target="../media/image33.png"/><Relationship Id="rId4" Type="http://schemas.openxmlformats.org/officeDocument/2006/relationships/image" Target="../media/image27.png"/><Relationship Id="rId9" Type="http://schemas.openxmlformats.org/officeDocument/2006/relationships/image" Target="../media/image3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77275E2-1592-3FBD-A9B2-E7959478E01D}"/>
              </a:ext>
            </a:extLst>
          </p:cNvPr>
          <p:cNvSpPr txBox="1"/>
          <p:nvPr/>
        </p:nvSpPr>
        <p:spPr>
          <a:xfrm>
            <a:off x="542116" y="149111"/>
            <a:ext cx="3962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2C: P-NF-</a:t>
            </a:r>
            <a:r>
              <a:rPr lang="el-G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κ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P65 –RAW264.7</a:t>
            </a:r>
          </a:p>
        </p:txBody>
      </p:sp>
      <p:pic>
        <p:nvPicPr>
          <p:cNvPr id="6" name="Picture 5" descr="A close-up of a dna test&#10;&#10;Description automatically generated">
            <a:extLst>
              <a:ext uri="{FF2B5EF4-FFF2-40B4-BE49-F238E27FC236}">
                <a16:creationId xmlns:a16="http://schemas.microsoft.com/office/drawing/2014/main" id="{5FA7248B-F67C-9375-B8EB-117D7D3AF07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626" y="4158033"/>
            <a:ext cx="1894109" cy="1813965"/>
          </a:xfrm>
          <a:prstGeom prst="rect">
            <a:avLst/>
          </a:prstGeom>
        </p:spPr>
      </p:pic>
      <p:pic>
        <p:nvPicPr>
          <p:cNvPr id="10" name="Picture 9" descr="A close-up of a test&#10;&#10;Description automatically generated">
            <a:extLst>
              <a:ext uri="{FF2B5EF4-FFF2-40B4-BE49-F238E27FC236}">
                <a16:creationId xmlns:a16="http://schemas.microsoft.com/office/drawing/2014/main" id="{5A009302-CD20-A1CF-A151-C44EF9BE70C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372" y="947207"/>
            <a:ext cx="1797707" cy="2494072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F41B2151-51B8-0FFE-F6FD-95EB561D61E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09699" y="3919317"/>
            <a:ext cx="1785483" cy="2273567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1C87110E-50C2-4A9B-7386-3145D8348CD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911970" y="4085981"/>
            <a:ext cx="1997947" cy="2199534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14728815-C021-6AB5-2143-9C592D863C4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349423" y="1203729"/>
            <a:ext cx="1797708" cy="2273568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E61E4FBB-1231-7A9D-5DD4-7D22EE7BA1F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065727" y="964900"/>
            <a:ext cx="1899858" cy="2496636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AA1D94D1-BB51-DE58-2152-0BA57BD5F2AC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349835" y="3819829"/>
            <a:ext cx="1984956" cy="2402842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1F4FF6F4-5021-0D68-E9D4-69B3A9F69BC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297830" y="1021444"/>
            <a:ext cx="2132997" cy="2225721"/>
          </a:xfrm>
          <a:prstGeom prst="rect">
            <a:avLst/>
          </a:prstGeom>
        </p:spPr>
      </p:pic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981E6934-E147-32F2-1D20-0DF9D7DC0C58}"/>
              </a:ext>
            </a:extLst>
          </p:cNvPr>
          <p:cNvCxnSpPr>
            <a:cxnSpLocks/>
          </p:cNvCxnSpPr>
          <p:nvPr/>
        </p:nvCxnSpPr>
        <p:spPr>
          <a:xfrm flipH="1">
            <a:off x="3339553" y="2655522"/>
            <a:ext cx="255293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TextBox 6">
            <a:extLst>
              <a:ext uri="{FF2B5EF4-FFF2-40B4-BE49-F238E27FC236}">
                <a16:creationId xmlns:a16="http://schemas.microsoft.com/office/drawing/2014/main" id="{AE896DD5-BC82-3941-A4F0-07F8E3DAFD32}"/>
              </a:ext>
            </a:extLst>
          </p:cNvPr>
          <p:cNvSpPr txBox="1"/>
          <p:nvPr/>
        </p:nvSpPr>
        <p:spPr>
          <a:xfrm>
            <a:off x="11259151" y="204199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65 KD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54EEBBC6-CD1D-A2AA-0F86-508E80C3A07F}"/>
              </a:ext>
            </a:extLst>
          </p:cNvPr>
          <p:cNvCxnSpPr>
            <a:cxnSpLocks/>
          </p:cNvCxnSpPr>
          <p:nvPr/>
        </p:nvCxnSpPr>
        <p:spPr>
          <a:xfrm flipH="1">
            <a:off x="10965585" y="2184686"/>
            <a:ext cx="255293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F3BB3B22-BE43-75B7-E380-645DE16A6E85}"/>
              </a:ext>
            </a:extLst>
          </p:cNvPr>
          <p:cNvSpPr txBox="1"/>
          <p:nvPr/>
        </p:nvSpPr>
        <p:spPr>
          <a:xfrm>
            <a:off x="11176408" y="508089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43 KD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A9E89E12-FF46-ED38-D945-37DE468E74AD}"/>
              </a:ext>
            </a:extLst>
          </p:cNvPr>
          <p:cNvCxnSpPr>
            <a:cxnSpLocks/>
          </p:cNvCxnSpPr>
          <p:nvPr/>
        </p:nvCxnSpPr>
        <p:spPr>
          <a:xfrm flipH="1">
            <a:off x="8147131" y="2171534"/>
            <a:ext cx="255293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600C7991-EA39-5D97-70D0-DAEEB6673228}"/>
              </a:ext>
            </a:extLst>
          </p:cNvPr>
          <p:cNvSpPr txBox="1"/>
          <p:nvPr/>
        </p:nvSpPr>
        <p:spPr>
          <a:xfrm>
            <a:off x="8284673" y="5067785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43 KD</a:t>
            </a:r>
          </a:p>
        </p:txBody>
      </p: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F60FA643-AC59-5D68-99A8-EB3DD8FA242E}"/>
              </a:ext>
            </a:extLst>
          </p:cNvPr>
          <p:cNvCxnSpPr>
            <a:cxnSpLocks/>
          </p:cNvCxnSpPr>
          <p:nvPr/>
        </p:nvCxnSpPr>
        <p:spPr>
          <a:xfrm flipH="1">
            <a:off x="5432579" y="5056101"/>
            <a:ext cx="255293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C5AB4ACB-FC05-F983-4970-D1D4400DF6AD}"/>
              </a:ext>
            </a:extLst>
          </p:cNvPr>
          <p:cNvSpPr txBox="1"/>
          <p:nvPr/>
        </p:nvSpPr>
        <p:spPr>
          <a:xfrm>
            <a:off x="2583643" y="169015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65 KD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E6C60176-B9BA-D799-3662-545733196B40}"/>
              </a:ext>
            </a:extLst>
          </p:cNvPr>
          <p:cNvCxnSpPr>
            <a:cxnSpLocks/>
          </p:cNvCxnSpPr>
          <p:nvPr/>
        </p:nvCxnSpPr>
        <p:spPr>
          <a:xfrm flipH="1">
            <a:off x="5430827" y="2318998"/>
            <a:ext cx="255293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545DD92B-FDCC-88CC-8B12-398B4741DA4C}"/>
              </a:ext>
            </a:extLst>
          </p:cNvPr>
          <p:cNvSpPr txBox="1"/>
          <p:nvPr/>
        </p:nvSpPr>
        <p:spPr>
          <a:xfrm>
            <a:off x="5644702" y="4909247"/>
            <a:ext cx="5533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33KD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8ADB3B33-8636-99E7-BA21-26FE41A95F49}"/>
              </a:ext>
            </a:extLst>
          </p:cNvPr>
          <p:cNvCxnSpPr>
            <a:cxnSpLocks/>
          </p:cNvCxnSpPr>
          <p:nvPr/>
        </p:nvCxnSpPr>
        <p:spPr>
          <a:xfrm flipH="1">
            <a:off x="2395669" y="5065015"/>
            <a:ext cx="255293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B9FDD486-AEDF-927A-E64F-7A1C3544FCEF}"/>
              </a:ext>
            </a:extLst>
          </p:cNvPr>
          <p:cNvSpPr txBox="1"/>
          <p:nvPr/>
        </p:nvSpPr>
        <p:spPr>
          <a:xfrm>
            <a:off x="8422407" y="2008154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65 KD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8CBB48FA-9777-D92F-5F3F-1180961699AA}"/>
              </a:ext>
            </a:extLst>
          </p:cNvPr>
          <p:cNvCxnSpPr>
            <a:cxnSpLocks/>
          </p:cNvCxnSpPr>
          <p:nvPr/>
        </p:nvCxnSpPr>
        <p:spPr>
          <a:xfrm flipH="1">
            <a:off x="2328350" y="1828658"/>
            <a:ext cx="255293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430F5A21-BDF4-3583-04F8-BAE4E6775236}"/>
              </a:ext>
            </a:extLst>
          </p:cNvPr>
          <p:cNvSpPr txBox="1"/>
          <p:nvPr/>
        </p:nvSpPr>
        <p:spPr>
          <a:xfrm>
            <a:off x="5671104" y="218049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65 KD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58369DAE-8609-F305-27E7-3974D479EBAD}"/>
              </a:ext>
            </a:extLst>
          </p:cNvPr>
          <p:cNvSpPr txBox="1"/>
          <p:nvPr/>
        </p:nvSpPr>
        <p:spPr>
          <a:xfrm>
            <a:off x="1075134" y="635485"/>
            <a:ext cx="9685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P-NF-</a:t>
            </a:r>
            <a:r>
              <a:rPr lang="el-GR" sz="1100" b="1" dirty="0"/>
              <a:t>κ</a:t>
            </a:r>
            <a:r>
              <a:rPr lang="en-US" sz="1100" b="1" dirty="0"/>
              <a:t>B p65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6858C2A-D400-C343-CA22-8D3E1E93C72D}"/>
              </a:ext>
            </a:extLst>
          </p:cNvPr>
          <p:cNvSpPr txBox="1"/>
          <p:nvPr/>
        </p:nvSpPr>
        <p:spPr>
          <a:xfrm>
            <a:off x="3952801" y="706244"/>
            <a:ext cx="9685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P-NF-</a:t>
            </a:r>
            <a:r>
              <a:rPr lang="el-GR" sz="1100" b="1" dirty="0"/>
              <a:t>κ</a:t>
            </a:r>
            <a:r>
              <a:rPr lang="en-US" sz="1100" b="1" dirty="0"/>
              <a:t>B p65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5841439-6399-6A9B-50E8-78AB71B731D6}"/>
              </a:ext>
            </a:extLst>
          </p:cNvPr>
          <p:cNvSpPr txBox="1"/>
          <p:nvPr/>
        </p:nvSpPr>
        <p:spPr>
          <a:xfrm>
            <a:off x="6748474" y="703290"/>
            <a:ext cx="9685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P-NF-</a:t>
            </a:r>
            <a:r>
              <a:rPr lang="el-GR" sz="1100" b="1" dirty="0"/>
              <a:t>κ</a:t>
            </a:r>
            <a:r>
              <a:rPr lang="en-US" sz="1100" b="1" dirty="0"/>
              <a:t>B p65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794CE44-8FB9-C3C5-DF77-17F4A37524B6}"/>
              </a:ext>
            </a:extLst>
          </p:cNvPr>
          <p:cNvSpPr txBox="1"/>
          <p:nvPr/>
        </p:nvSpPr>
        <p:spPr>
          <a:xfrm>
            <a:off x="9664063" y="572485"/>
            <a:ext cx="9685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P-NF-</a:t>
            </a:r>
            <a:r>
              <a:rPr lang="el-GR" sz="1100" b="1" dirty="0"/>
              <a:t>κ</a:t>
            </a:r>
            <a:r>
              <a:rPr lang="en-US" sz="1100" b="1" dirty="0"/>
              <a:t>B p65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8DE2242-4E09-E40D-2432-F399DA8C720B}"/>
              </a:ext>
            </a:extLst>
          </p:cNvPr>
          <p:cNvSpPr txBox="1"/>
          <p:nvPr/>
        </p:nvSpPr>
        <p:spPr>
          <a:xfrm>
            <a:off x="1283087" y="3510854"/>
            <a:ext cx="6447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100" b="1" dirty="0"/>
              <a:t>β</a:t>
            </a:r>
            <a:r>
              <a:rPr lang="en-US" sz="1100" b="1" dirty="0"/>
              <a:t>-actin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9CB03332-DB48-CA6F-0708-77AB6BCAC7EC}"/>
              </a:ext>
            </a:extLst>
          </p:cNvPr>
          <p:cNvSpPr txBox="1"/>
          <p:nvPr/>
        </p:nvSpPr>
        <p:spPr>
          <a:xfrm>
            <a:off x="6841295" y="3575686"/>
            <a:ext cx="6447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100" b="1" dirty="0"/>
              <a:t>β</a:t>
            </a:r>
            <a:r>
              <a:rPr lang="en-US" sz="1100" b="1" dirty="0"/>
              <a:t>-actin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DDB3820-E944-20F1-BCBF-F933A6506E94}"/>
              </a:ext>
            </a:extLst>
          </p:cNvPr>
          <p:cNvSpPr txBox="1"/>
          <p:nvPr/>
        </p:nvSpPr>
        <p:spPr>
          <a:xfrm>
            <a:off x="3867269" y="3543270"/>
            <a:ext cx="6447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100" b="1" dirty="0"/>
              <a:t>β</a:t>
            </a:r>
            <a:r>
              <a:rPr lang="en-US" sz="1100" b="1" dirty="0"/>
              <a:t>-actin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DF73B5B8-64EB-FE5B-B06F-29DA65DBDCF1}"/>
              </a:ext>
            </a:extLst>
          </p:cNvPr>
          <p:cNvSpPr txBox="1"/>
          <p:nvPr/>
        </p:nvSpPr>
        <p:spPr>
          <a:xfrm>
            <a:off x="9815321" y="3706491"/>
            <a:ext cx="6447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100" b="1" dirty="0"/>
              <a:t>β</a:t>
            </a:r>
            <a:r>
              <a:rPr lang="en-US" sz="1100" b="1" dirty="0"/>
              <a:t>-actin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E05F3F4D-59DA-780F-FA55-CCA89B464278}"/>
              </a:ext>
            </a:extLst>
          </p:cNvPr>
          <p:cNvSpPr txBox="1"/>
          <p:nvPr/>
        </p:nvSpPr>
        <p:spPr>
          <a:xfrm>
            <a:off x="2629716" y="4929286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43 KD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1B2D2EC1-A25E-E056-4976-4E94EFB0CA1E}"/>
              </a:ext>
            </a:extLst>
          </p:cNvPr>
          <p:cNvCxnSpPr>
            <a:cxnSpLocks/>
          </p:cNvCxnSpPr>
          <p:nvPr/>
        </p:nvCxnSpPr>
        <p:spPr>
          <a:xfrm flipH="1">
            <a:off x="10921115" y="5273322"/>
            <a:ext cx="255293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AC27A54E-CA04-2EE6-2325-58B9D702A9E4}"/>
              </a:ext>
            </a:extLst>
          </p:cNvPr>
          <p:cNvCxnSpPr>
            <a:cxnSpLocks/>
          </p:cNvCxnSpPr>
          <p:nvPr/>
        </p:nvCxnSpPr>
        <p:spPr>
          <a:xfrm flipH="1">
            <a:off x="8044238" y="5206285"/>
            <a:ext cx="255293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725209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FAFCAAA8-6CDD-EDE8-7F84-81D0C339925D}"/>
              </a:ext>
            </a:extLst>
          </p:cNvPr>
          <p:cNvSpPr txBox="1"/>
          <p:nvPr/>
        </p:nvSpPr>
        <p:spPr>
          <a:xfrm>
            <a:off x="462284" y="208982"/>
            <a:ext cx="2655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6A: MYD88-Mice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A3B566EF-7ED6-A0B0-4246-CF90533AB57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56978" y="1347574"/>
            <a:ext cx="1390844" cy="1991003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78041BE5-1798-BFE8-D518-4C6BE243D29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93504" y="4084291"/>
            <a:ext cx="1514686" cy="1848108"/>
          </a:xfrm>
          <a:prstGeom prst="rect">
            <a:avLst/>
          </a:prstGeom>
        </p:spPr>
      </p:pic>
      <p:pic>
        <p:nvPicPr>
          <p:cNvPr id="13" name="Picture 12" descr="A close up of a white background&#10;&#10;Description automatically generated">
            <a:extLst>
              <a:ext uri="{FF2B5EF4-FFF2-40B4-BE49-F238E27FC236}">
                <a16:creationId xmlns:a16="http://schemas.microsoft.com/office/drawing/2014/main" id="{6C5DD1EF-AFD1-99F6-C385-86660D9933F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86681" y="1224807"/>
            <a:ext cx="1165412" cy="1959864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46498615-51FC-8416-EFCF-DF86D14AD3C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068722" y="1053951"/>
            <a:ext cx="1214611" cy="2284626"/>
          </a:xfrm>
          <a:prstGeom prst="rect">
            <a:avLst/>
          </a:prstGeom>
        </p:spPr>
      </p:pic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B16DC6CD-6E4A-0136-994D-8A012A4EF5FB}"/>
              </a:ext>
            </a:extLst>
          </p:cNvPr>
          <p:cNvCxnSpPr>
            <a:cxnSpLocks/>
          </p:cNvCxnSpPr>
          <p:nvPr/>
        </p:nvCxnSpPr>
        <p:spPr>
          <a:xfrm flipH="1">
            <a:off x="3339553" y="2655522"/>
            <a:ext cx="255293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EFA31A8D-ADEC-D65C-DAF4-BB94CB2E2A3B}"/>
              </a:ext>
            </a:extLst>
          </p:cNvPr>
          <p:cNvCxnSpPr>
            <a:cxnSpLocks/>
          </p:cNvCxnSpPr>
          <p:nvPr/>
        </p:nvCxnSpPr>
        <p:spPr>
          <a:xfrm flipH="1">
            <a:off x="5820121" y="2652804"/>
            <a:ext cx="255293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2" name="TextBox 31">
            <a:extLst>
              <a:ext uri="{FF2B5EF4-FFF2-40B4-BE49-F238E27FC236}">
                <a16:creationId xmlns:a16="http://schemas.microsoft.com/office/drawing/2014/main" id="{A1CD494D-4889-6965-1506-6164E8FB02E0}"/>
              </a:ext>
            </a:extLst>
          </p:cNvPr>
          <p:cNvSpPr txBox="1"/>
          <p:nvPr/>
        </p:nvSpPr>
        <p:spPr>
          <a:xfrm>
            <a:off x="3590116" y="2514305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33 KD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D3637729-3E45-1BD0-7CEF-1F8A185E5551}"/>
              </a:ext>
            </a:extLst>
          </p:cNvPr>
          <p:cNvSpPr txBox="1"/>
          <p:nvPr/>
        </p:nvSpPr>
        <p:spPr>
          <a:xfrm>
            <a:off x="6054264" y="2514304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33 KD</a:t>
            </a:r>
          </a:p>
        </p:txBody>
      </p: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F52D2A4F-67F5-DF29-7250-C9DA4763ACB2}"/>
              </a:ext>
            </a:extLst>
          </p:cNvPr>
          <p:cNvCxnSpPr>
            <a:cxnSpLocks/>
          </p:cNvCxnSpPr>
          <p:nvPr/>
        </p:nvCxnSpPr>
        <p:spPr>
          <a:xfrm flipH="1">
            <a:off x="8231627" y="2724521"/>
            <a:ext cx="255293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209A6706-3F84-7F0A-7B15-AFF0713E9D21}"/>
              </a:ext>
            </a:extLst>
          </p:cNvPr>
          <p:cNvSpPr txBox="1"/>
          <p:nvPr/>
        </p:nvSpPr>
        <p:spPr>
          <a:xfrm>
            <a:off x="8486920" y="2586021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33 KD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2C835B6-5DFF-E142-D1E9-D9D9E6CD7C4A}"/>
              </a:ext>
            </a:extLst>
          </p:cNvPr>
          <p:cNvSpPr txBox="1"/>
          <p:nvPr/>
        </p:nvSpPr>
        <p:spPr>
          <a:xfrm>
            <a:off x="10790849" y="2625159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33 KD</a:t>
            </a:r>
          </a:p>
        </p:txBody>
      </p: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9F2A5D4B-8601-A8AB-522D-0E73757128C7}"/>
              </a:ext>
            </a:extLst>
          </p:cNvPr>
          <p:cNvCxnSpPr>
            <a:cxnSpLocks/>
          </p:cNvCxnSpPr>
          <p:nvPr/>
        </p:nvCxnSpPr>
        <p:spPr>
          <a:xfrm flipH="1">
            <a:off x="10463839" y="2763659"/>
            <a:ext cx="255293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48A35854-9470-0D6B-619C-2304CEC9BF18}"/>
              </a:ext>
            </a:extLst>
          </p:cNvPr>
          <p:cNvSpPr txBox="1"/>
          <p:nvPr/>
        </p:nvSpPr>
        <p:spPr>
          <a:xfrm>
            <a:off x="2352633" y="925601"/>
            <a:ext cx="6335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MYD88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90F09B2-7D0E-9A98-1B3D-FD4B79AA65FC}"/>
              </a:ext>
            </a:extLst>
          </p:cNvPr>
          <p:cNvSpPr txBox="1"/>
          <p:nvPr/>
        </p:nvSpPr>
        <p:spPr>
          <a:xfrm>
            <a:off x="7274257" y="663991"/>
            <a:ext cx="6335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MYD88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263EF908-9E86-8FC5-F65F-E277C683F8D7}"/>
              </a:ext>
            </a:extLst>
          </p:cNvPr>
          <p:cNvSpPr txBox="1"/>
          <p:nvPr/>
        </p:nvSpPr>
        <p:spPr>
          <a:xfrm>
            <a:off x="4602670" y="916944"/>
            <a:ext cx="6335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MYD88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2BA23DA-632C-21F4-E6F3-2348B841420C}"/>
              </a:ext>
            </a:extLst>
          </p:cNvPr>
          <p:cNvSpPr txBox="1"/>
          <p:nvPr/>
        </p:nvSpPr>
        <p:spPr>
          <a:xfrm>
            <a:off x="9290805" y="771054"/>
            <a:ext cx="6335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MYD88</a:t>
            </a:r>
          </a:p>
        </p:txBody>
      </p:sp>
      <p:pic>
        <p:nvPicPr>
          <p:cNvPr id="46" name="Picture 45">
            <a:extLst>
              <a:ext uri="{FF2B5EF4-FFF2-40B4-BE49-F238E27FC236}">
                <a16:creationId xmlns:a16="http://schemas.microsoft.com/office/drawing/2014/main" id="{2B971550-1382-DB50-50B2-0461B6CE9A6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791524" y="1057113"/>
            <a:ext cx="1411658" cy="2295252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A859D42C-F1E2-0113-EE65-3DF9F47CBD0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444520" y="4629326"/>
            <a:ext cx="1386993" cy="1311730"/>
          </a:xfrm>
          <a:prstGeom prst="rect">
            <a:avLst/>
          </a:prstGeom>
        </p:spPr>
      </p:pic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E29AE85E-12AB-DC2C-CD52-2B1B12FF2FDF}"/>
              </a:ext>
            </a:extLst>
          </p:cNvPr>
          <p:cNvCxnSpPr>
            <a:cxnSpLocks/>
          </p:cNvCxnSpPr>
          <p:nvPr/>
        </p:nvCxnSpPr>
        <p:spPr>
          <a:xfrm flipH="1">
            <a:off x="3611501" y="5595945"/>
            <a:ext cx="255293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9FF9BFB2-D4E6-3B90-C58C-29A484E88048}"/>
              </a:ext>
            </a:extLst>
          </p:cNvPr>
          <p:cNvSpPr txBox="1"/>
          <p:nvPr/>
        </p:nvSpPr>
        <p:spPr>
          <a:xfrm>
            <a:off x="10514170" y="5059961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43 KD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25961F17-3948-D762-D22E-D1B8E443D4C1}"/>
              </a:ext>
            </a:extLst>
          </p:cNvPr>
          <p:cNvSpPr txBox="1"/>
          <p:nvPr/>
        </p:nvSpPr>
        <p:spPr>
          <a:xfrm>
            <a:off x="6187262" y="5285191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43 KD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EFD9FD77-2E82-844A-20AB-63732012F0A9}"/>
              </a:ext>
            </a:extLst>
          </p:cNvPr>
          <p:cNvSpPr txBox="1"/>
          <p:nvPr/>
        </p:nvSpPr>
        <p:spPr>
          <a:xfrm>
            <a:off x="3894916" y="5457445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43 KD</a:t>
            </a:r>
          </a:p>
        </p:txBody>
      </p: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0B9EE5BC-DEA8-DB9B-3AF4-8F7F2B9DFDD6}"/>
              </a:ext>
            </a:extLst>
          </p:cNvPr>
          <p:cNvCxnSpPr>
            <a:cxnSpLocks/>
          </p:cNvCxnSpPr>
          <p:nvPr/>
        </p:nvCxnSpPr>
        <p:spPr>
          <a:xfrm flipH="1">
            <a:off x="5926617" y="5423689"/>
            <a:ext cx="255293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3180A50D-5F3E-A8DF-9E29-E5789BB1150F}"/>
              </a:ext>
            </a:extLst>
          </p:cNvPr>
          <p:cNvCxnSpPr>
            <a:cxnSpLocks/>
          </p:cNvCxnSpPr>
          <p:nvPr/>
        </p:nvCxnSpPr>
        <p:spPr>
          <a:xfrm flipH="1">
            <a:off x="10283333" y="5198460"/>
            <a:ext cx="255293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E0814BFC-A6D1-CC73-6242-1918E3BBEB03}"/>
              </a:ext>
            </a:extLst>
          </p:cNvPr>
          <p:cNvSpPr txBox="1"/>
          <p:nvPr/>
        </p:nvSpPr>
        <p:spPr>
          <a:xfrm>
            <a:off x="8268605" y="5189453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43 KD</a:t>
            </a:r>
          </a:p>
        </p:txBody>
      </p: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E743A623-6618-B621-9EC8-3DC3780F0C79}"/>
              </a:ext>
            </a:extLst>
          </p:cNvPr>
          <p:cNvCxnSpPr>
            <a:cxnSpLocks/>
          </p:cNvCxnSpPr>
          <p:nvPr/>
        </p:nvCxnSpPr>
        <p:spPr>
          <a:xfrm flipH="1">
            <a:off x="8013312" y="5336960"/>
            <a:ext cx="255293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59" name="Picture 58">
            <a:extLst>
              <a:ext uri="{FF2B5EF4-FFF2-40B4-BE49-F238E27FC236}">
                <a16:creationId xmlns:a16="http://schemas.microsoft.com/office/drawing/2014/main" id="{34BE5735-DD33-C33E-C247-BFC6042B43C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722408" y="4434815"/>
            <a:ext cx="1266328" cy="1977748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id="{33DA187C-7176-9857-4B41-962AF5AD1FD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9031695" y="4381589"/>
            <a:ext cx="1075856" cy="215171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5F464FFE-10A5-ACF7-EF68-BBA37AC03FC8}"/>
              </a:ext>
            </a:extLst>
          </p:cNvPr>
          <p:cNvSpPr txBox="1"/>
          <p:nvPr/>
        </p:nvSpPr>
        <p:spPr>
          <a:xfrm>
            <a:off x="2607365" y="3700359"/>
            <a:ext cx="6447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100" b="1" dirty="0"/>
              <a:t>β</a:t>
            </a:r>
            <a:r>
              <a:rPr lang="en-US" sz="1100" b="1" dirty="0"/>
              <a:t>-actin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B2B8011-358C-DFD3-37A7-6A884E0F5C35}"/>
              </a:ext>
            </a:extLst>
          </p:cNvPr>
          <p:cNvSpPr txBox="1"/>
          <p:nvPr/>
        </p:nvSpPr>
        <p:spPr>
          <a:xfrm>
            <a:off x="4913813" y="3890994"/>
            <a:ext cx="6447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100" b="1" dirty="0"/>
              <a:t>β</a:t>
            </a:r>
            <a:r>
              <a:rPr lang="en-US" sz="1100" b="1" dirty="0"/>
              <a:t>-actin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68BD4D7-B540-A975-7141-28C3A9F92D42}"/>
              </a:ext>
            </a:extLst>
          </p:cNvPr>
          <p:cNvSpPr txBox="1"/>
          <p:nvPr/>
        </p:nvSpPr>
        <p:spPr>
          <a:xfrm>
            <a:off x="7174989" y="3924864"/>
            <a:ext cx="6447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100" b="1" dirty="0"/>
              <a:t>β</a:t>
            </a:r>
            <a:r>
              <a:rPr lang="en-US" sz="1100" b="1" dirty="0"/>
              <a:t>-actin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95425E9-6EA8-5CEA-5B25-E7276112EF2D}"/>
              </a:ext>
            </a:extLst>
          </p:cNvPr>
          <p:cNvSpPr txBox="1"/>
          <p:nvPr/>
        </p:nvSpPr>
        <p:spPr>
          <a:xfrm>
            <a:off x="9353663" y="3890994"/>
            <a:ext cx="6447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100" b="1" dirty="0"/>
              <a:t>β</a:t>
            </a:r>
            <a:r>
              <a:rPr lang="en-US" sz="1100" b="1" dirty="0"/>
              <a:t>-actin</a:t>
            </a:r>
          </a:p>
        </p:txBody>
      </p:sp>
    </p:spTree>
    <p:extLst>
      <p:ext uri="{BB962C8B-B14F-4D97-AF65-F5344CB8AC3E}">
        <p14:creationId xmlns:p14="http://schemas.microsoft.com/office/powerpoint/2010/main" val="15767088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A close-up of a test&#10;&#10;Description automatically generated">
            <a:extLst>
              <a:ext uri="{FF2B5EF4-FFF2-40B4-BE49-F238E27FC236}">
                <a16:creationId xmlns:a16="http://schemas.microsoft.com/office/drawing/2014/main" id="{4CC6BEF4-4119-D39A-51FC-5AD37FC3138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1623" y="1139872"/>
            <a:ext cx="2014728" cy="1901952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7A5A20AB-9B02-6842-4163-134D7C3776F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54411" y="4144825"/>
            <a:ext cx="1228896" cy="1771897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230F42B9-45FE-0473-D6D0-CBBFECE3F25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21497" y="1332422"/>
            <a:ext cx="1278815" cy="1722751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0D9D623E-5DEE-8D7B-40FC-AE1F78E65C2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96013" y="3747859"/>
            <a:ext cx="1326776" cy="2168863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A6DA3F8D-AE05-2304-6D9E-B0764F08CBAD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323972" y="3912368"/>
            <a:ext cx="1657412" cy="2168863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354427DE-78E7-1640-A162-6332A0590E0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595089" y="3968110"/>
            <a:ext cx="1519176" cy="1904638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9D2C8985-6B08-F976-86B1-F790789F891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647034" y="1394418"/>
            <a:ext cx="1416684" cy="1757082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0132B54B-D830-C9BB-FF2C-06E54C7C542B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8338859" y="1365948"/>
            <a:ext cx="1761825" cy="190195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1CA8FE1-DDAE-7EEF-4FC5-CD5072597B0D}"/>
              </a:ext>
            </a:extLst>
          </p:cNvPr>
          <p:cNvSpPr txBox="1"/>
          <p:nvPr/>
        </p:nvSpPr>
        <p:spPr>
          <a:xfrm>
            <a:off x="542116" y="149111"/>
            <a:ext cx="3962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6B: P-NF-</a:t>
            </a:r>
            <a:r>
              <a:rPr lang="el-G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κ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P65 –mice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E105411-2FCE-8C26-E8D2-B6F55C383B99}"/>
              </a:ext>
            </a:extLst>
          </p:cNvPr>
          <p:cNvSpPr txBox="1"/>
          <p:nvPr/>
        </p:nvSpPr>
        <p:spPr>
          <a:xfrm>
            <a:off x="1282087" y="889745"/>
            <a:ext cx="9685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P-NF-</a:t>
            </a:r>
            <a:r>
              <a:rPr lang="el-GR" sz="1100" b="1" dirty="0"/>
              <a:t>κ</a:t>
            </a:r>
            <a:r>
              <a:rPr lang="en-US" sz="1100" b="1" dirty="0"/>
              <a:t>B p65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ED7DFCB-473B-245A-2775-9D2B2C8D7504}"/>
              </a:ext>
            </a:extLst>
          </p:cNvPr>
          <p:cNvSpPr txBox="1"/>
          <p:nvPr/>
        </p:nvSpPr>
        <p:spPr>
          <a:xfrm>
            <a:off x="8433360" y="810473"/>
            <a:ext cx="9685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P-NF-</a:t>
            </a:r>
            <a:r>
              <a:rPr lang="el-GR" sz="1100" b="1" dirty="0"/>
              <a:t>κ</a:t>
            </a:r>
            <a:r>
              <a:rPr lang="en-US" sz="1100" b="1" dirty="0"/>
              <a:t>B p65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6A1171C-E21B-94A7-65F1-014E796647CD}"/>
              </a:ext>
            </a:extLst>
          </p:cNvPr>
          <p:cNvSpPr txBox="1"/>
          <p:nvPr/>
        </p:nvSpPr>
        <p:spPr>
          <a:xfrm>
            <a:off x="5904440" y="941278"/>
            <a:ext cx="9685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P-NF-</a:t>
            </a:r>
            <a:r>
              <a:rPr lang="el-GR" sz="1100" b="1" dirty="0"/>
              <a:t>κ</a:t>
            </a:r>
            <a:r>
              <a:rPr lang="en-US" sz="1100" b="1" dirty="0"/>
              <a:t>B p65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691A478-918F-EB90-A106-6F2872247559}"/>
              </a:ext>
            </a:extLst>
          </p:cNvPr>
          <p:cNvSpPr txBox="1"/>
          <p:nvPr/>
        </p:nvSpPr>
        <p:spPr>
          <a:xfrm>
            <a:off x="3597680" y="889745"/>
            <a:ext cx="9685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/>
              <a:t>P-NF-</a:t>
            </a:r>
            <a:r>
              <a:rPr lang="el-GR" sz="1100" b="1" dirty="0"/>
              <a:t>κ</a:t>
            </a:r>
            <a:r>
              <a:rPr lang="en-US" sz="1100" b="1" dirty="0"/>
              <a:t>B p65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3457790-2319-698E-B2A1-25758111C6CC}"/>
              </a:ext>
            </a:extLst>
          </p:cNvPr>
          <p:cNvSpPr txBox="1"/>
          <p:nvPr/>
        </p:nvSpPr>
        <p:spPr>
          <a:xfrm>
            <a:off x="1317879" y="3370823"/>
            <a:ext cx="6447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100" b="1" dirty="0"/>
              <a:t>β</a:t>
            </a:r>
            <a:r>
              <a:rPr lang="en-US" sz="1100" b="1" dirty="0"/>
              <a:t>-actin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BC0E59A-05AD-C616-45F2-0340A58C3579}"/>
              </a:ext>
            </a:extLst>
          </p:cNvPr>
          <p:cNvSpPr txBox="1"/>
          <p:nvPr/>
        </p:nvSpPr>
        <p:spPr>
          <a:xfrm>
            <a:off x="3596737" y="3370823"/>
            <a:ext cx="6447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100" b="1" dirty="0"/>
              <a:t>β</a:t>
            </a:r>
            <a:r>
              <a:rPr lang="en-US" sz="1100" b="1" dirty="0"/>
              <a:t>-acti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FF1F6F3-9265-FD8F-2F08-2DE3F38A3344}"/>
              </a:ext>
            </a:extLst>
          </p:cNvPr>
          <p:cNvSpPr txBox="1"/>
          <p:nvPr/>
        </p:nvSpPr>
        <p:spPr>
          <a:xfrm>
            <a:off x="8595264" y="3460424"/>
            <a:ext cx="6447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100" b="1" dirty="0"/>
              <a:t>β</a:t>
            </a:r>
            <a:r>
              <a:rPr lang="en-US" sz="1100" b="1" dirty="0"/>
              <a:t>-acti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D21EB27-EE3B-F449-2618-4F1BB8B5648C}"/>
              </a:ext>
            </a:extLst>
          </p:cNvPr>
          <p:cNvSpPr txBox="1"/>
          <p:nvPr/>
        </p:nvSpPr>
        <p:spPr>
          <a:xfrm>
            <a:off x="6066343" y="3429000"/>
            <a:ext cx="6447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100" b="1" dirty="0"/>
              <a:t>β</a:t>
            </a:r>
            <a:r>
              <a:rPr lang="en-US" sz="1100" b="1" dirty="0"/>
              <a:t>-actin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F0F5CAA-06F6-84B5-7FD4-A9CFA6CACA0D}"/>
              </a:ext>
            </a:extLst>
          </p:cNvPr>
          <p:cNvSpPr txBox="1"/>
          <p:nvPr/>
        </p:nvSpPr>
        <p:spPr>
          <a:xfrm>
            <a:off x="2671693" y="2272959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65 KD</a:t>
            </a: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D67E4FE6-4D43-670E-D7A1-3CB24C244687}"/>
              </a:ext>
            </a:extLst>
          </p:cNvPr>
          <p:cNvCxnSpPr>
            <a:cxnSpLocks/>
          </p:cNvCxnSpPr>
          <p:nvPr/>
        </p:nvCxnSpPr>
        <p:spPr>
          <a:xfrm flipH="1">
            <a:off x="2395669" y="2446601"/>
            <a:ext cx="255293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" name="TextBox 15">
            <a:extLst>
              <a:ext uri="{FF2B5EF4-FFF2-40B4-BE49-F238E27FC236}">
                <a16:creationId xmlns:a16="http://schemas.microsoft.com/office/drawing/2014/main" id="{A07878BB-B6F1-4EFF-1143-6190FC9D0F6E}"/>
              </a:ext>
            </a:extLst>
          </p:cNvPr>
          <p:cNvSpPr txBox="1"/>
          <p:nvPr/>
        </p:nvSpPr>
        <p:spPr>
          <a:xfrm>
            <a:off x="10423070" y="2265131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65 KD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8096C5B6-19F8-2EE3-02A9-D18527EE319C}"/>
              </a:ext>
            </a:extLst>
          </p:cNvPr>
          <p:cNvCxnSpPr>
            <a:cxnSpLocks/>
          </p:cNvCxnSpPr>
          <p:nvPr/>
        </p:nvCxnSpPr>
        <p:spPr>
          <a:xfrm flipH="1">
            <a:off x="10208146" y="2411457"/>
            <a:ext cx="255293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6A658762-6ED0-2009-431F-0836AC0A11B6}"/>
              </a:ext>
            </a:extLst>
          </p:cNvPr>
          <p:cNvSpPr txBox="1"/>
          <p:nvPr/>
        </p:nvSpPr>
        <p:spPr>
          <a:xfrm>
            <a:off x="7441021" y="2272958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65 KD</a:t>
            </a:r>
          </a:p>
        </p:txBody>
      </p: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947BA7F9-1163-897E-1356-CB8719CFC1F0}"/>
              </a:ext>
            </a:extLst>
          </p:cNvPr>
          <p:cNvCxnSpPr>
            <a:cxnSpLocks/>
          </p:cNvCxnSpPr>
          <p:nvPr/>
        </p:nvCxnSpPr>
        <p:spPr>
          <a:xfrm flipH="1">
            <a:off x="7185728" y="2411458"/>
            <a:ext cx="255293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92AAD4FA-EA77-E0D9-5111-C76E93735BD7}"/>
              </a:ext>
            </a:extLst>
          </p:cNvPr>
          <p:cNvSpPr txBox="1"/>
          <p:nvPr/>
        </p:nvSpPr>
        <p:spPr>
          <a:xfrm>
            <a:off x="4930360" y="2316924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65 KD</a:t>
            </a:r>
          </a:p>
        </p:txBody>
      </p: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CA0FFC2E-85A4-461D-629A-9620B5619662}"/>
              </a:ext>
            </a:extLst>
          </p:cNvPr>
          <p:cNvCxnSpPr>
            <a:cxnSpLocks/>
          </p:cNvCxnSpPr>
          <p:nvPr/>
        </p:nvCxnSpPr>
        <p:spPr>
          <a:xfrm flipH="1">
            <a:off x="4702347" y="2455424"/>
            <a:ext cx="255293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39A28CA4-C52A-E874-7DC5-88BB3373482A}"/>
              </a:ext>
            </a:extLst>
          </p:cNvPr>
          <p:cNvSpPr txBox="1"/>
          <p:nvPr/>
        </p:nvSpPr>
        <p:spPr>
          <a:xfrm>
            <a:off x="2519429" y="4814199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43 KD</a:t>
            </a:r>
          </a:p>
        </p:txBody>
      </p: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75788DB5-0F44-D29F-46A2-1E2B5D64527A}"/>
              </a:ext>
            </a:extLst>
          </p:cNvPr>
          <p:cNvCxnSpPr>
            <a:cxnSpLocks/>
          </p:cNvCxnSpPr>
          <p:nvPr/>
        </p:nvCxnSpPr>
        <p:spPr>
          <a:xfrm flipH="1">
            <a:off x="2268022" y="4968360"/>
            <a:ext cx="255293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8FEA544A-113B-48DF-51E4-8A4766867532}"/>
              </a:ext>
            </a:extLst>
          </p:cNvPr>
          <p:cNvSpPr txBox="1"/>
          <p:nvPr/>
        </p:nvSpPr>
        <p:spPr>
          <a:xfrm>
            <a:off x="4664932" y="4813000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43 KD</a:t>
            </a:r>
          </a:p>
        </p:txBody>
      </p: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74D6F67B-B755-DDCF-3E59-8240EDF7B14C}"/>
              </a:ext>
            </a:extLst>
          </p:cNvPr>
          <p:cNvCxnSpPr>
            <a:cxnSpLocks/>
          </p:cNvCxnSpPr>
          <p:nvPr/>
        </p:nvCxnSpPr>
        <p:spPr>
          <a:xfrm flipH="1">
            <a:off x="4520445" y="4951500"/>
            <a:ext cx="255293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32E5CDC1-B48F-0511-2E43-1E1C414885A0}"/>
              </a:ext>
            </a:extLst>
          </p:cNvPr>
          <p:cNvSpPr txBox="1"/>
          <p:nvPr/>
        </p:nvSpPr>
        <p:spPr>
          <a:xfrm>
            <a:off x="7389134" y="5354726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43 KD</a:t>
            </a:r>
          </a:p>
        </p:txBody>
      </p: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B2A58877-A53D-200B-319E-0C6C375CBCC4}"/>
              </a:ext>
            </a:extLst>
          </p:cNvPr>
          <p:cNvCxnSpPr>
            <a:cxnSpLocks/>
          </p:cNvCxnSpPr>
          <p:nvPr/>
        </p:nvCxnSpPr>
        <p:spPr>
          <a:xfrm flipH="1">
            <a:off x="7185727" y="5493226"/>
            <a:ext cx="255293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1C20A9BD-F13C-07EE-A751-3691A05B8F0D}"/>
              </a:ext>
            </a:extLst>
          </p:cNvPr>
          <p:cNvSpPr txBox="1"/>
          <p:nvPr/>
        </p:nvSpPr>
        <p:spPr>
          <a:xfrm>
            <a:off x="10202319" y="4892273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43 KD</a:t>
            </a:r>
          </a:p>
        </p:txBody>
      </p: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223DC2C0-0D8A-FE07-05BA-276D842C4826}"/>
              </a:ext>
            </a:extLst>
          </p:cNvPr>
          <p:cNvCxnSpPr>
            <a:cxnSpLocks/>
          </p:cNvCxnSpPr>
          <p:nvPr/>
        </p:nvCxnSpPr>
        <p:spPr>
          <a:xfrm flipH="1">
            <a:off x="9981384" y="5020009"/>
            <a:ext cx="255293" cy="0"/>
          </a:xfrm>
          <a:prstGeom prst="straightConnector1">
            <a:avLst/>
          </a:prstGeom>
          <a:ln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700305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40252628-585F-C1B2-360E-66339136B7C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84823" y="1388861"/>
            <a:ext cx="1562318" cy="154326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34254CD-35B6-05A9-89EE-39E1F725A62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40053" y="3000568"/>
            <a:ext cx="1571844" cy="1533739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822E53C8-F791-5A6E-D963-9B77FA43997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40053" y="4623928"/>
            <a:ext cx="1533739" cy="1543265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CE4DCD68-75F0-FA8B-E46D-55FE059C79E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09723" y="1388861"/>
            <a:ext cx="1562318" cy="1552792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2D525212-891B-D1A0-64FB-FC5EE4AD8F1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709723" y="3010094"/>
            <a:ext cx="1533739" cy="1524213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6CE8D2F7-035B-5CED-8D06-0AF1E461782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709723" y="4633455"/>
            <a:ext cx="1562318" cy="1524213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9961F391-0D83-AA75-3CF0-735FB5EC2B7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341288" y="3039737"/>
            <a:ext cx="1543265" cy="1514686"/>
          </a:xfrm>
          <a:prstGeom prst="rect">
            <a:avLst/>
          </a:prstGeom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E106BEF0-15F8-3FA0-E657-92B8C3F908D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312709" y="4633455"/>
            <a:ext cx="1571844" cy="1495634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E5AEB199-AFF8-66C8-2F05-2DACCCDC43F5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334623" y="1417440"/>
            <a:ext cx="1552792" cy="1514686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CE45560D-A1B2-0E31-45D7-6CE1D0465079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949997" y="1430575"/>
            <a:ext cx="1533739" cy="1562318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B003F28B-E926-1196-0A65-B67A878A542D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7930944" y="4638217"/>
            <a:ext cx="1552792" cy="1514686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804A2604-CB76-5F45-BA3C-D9C57A9DD968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940470" y="3058789"/>
            <a:ext cx="1552792" cy="1476581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A960DDA4-41EE-096A-8604-7B5A2FE0E42F}"/>
              </a:ext>
            </a:extLst>
          </p:cNvPr>
          <p:cNvSpPr txBox="1"/>
          <p:nvPr/>
        </p:nvSpPr>
        <p:spPr>
          <a:xfrm>
            <a:off x="1801832" y="1842402"/>
            <a:ext cx="9333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ntrol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EAB3AD6E-5D02-BE11-C6BC-1CC08D5BB87E}"/>
              </a:ext>
            </a:extLst>
          </p:cNvPr>
          <p:cNvSpPr txBox="1"/>
          <p:nvPr/>
        </p:nvSpPr>
        <p:spPr>
          <a:xfrm>
            <a:off x="1987010" y="3481824"/>
            <a:ext cx="5629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PS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5B5D775-1D6A-19AA-D13B-B871FEFCDB07}"/>
              </a:ext>
            </a:extLst>
          </p:cNvPr>
          <p:cNvSpPr txBox="1"/>
          <p:nvPr/>
        </p:nvSpPr>
        <p:spPr>
          <a:xfrm>
            <a:off x="1722417" y="5121246"/>
            <a:ext cx="12712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LPS/nSsnB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F8E04B9-3C10-A811-0F9C-6D3AE3D66820}"/>
              </a:ext>
            </a:extLst>
          </p:cNvPr>
          <p:cNvSpPr txBox="1"/>
          <p:nvPr/>
        </p:nvSpPr>
        <p:spPr>
          <a:xfrm>
            <a:off x="542115" y="149111"/>
            <a:ext cx="41676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6C: Activation of P-NF-</a:t>
            </a:r>
            <a:r>
              <a:rPr lang="el-GR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κ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 –mice</a:t>
            </a:r>
          </a:p>
        </p:txBody>
      </p:sp>
    </p:spTree>
    <p:extLst>
      <p:ext uri="{BB962C8B-B14F-4D97-AF65-F5344CB8AC3E}">
        <p14:creationId xmlns:p14="http://schemas.microsoft.com/office/powerpoint/2010/main" val="14567870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2</TotalTime>
  <Words>144</Words>
  <Application>Microsoft Office PowerPoint</Application>
  <PresentationFormat>Widescreen</PresentationFormat>
  <Paragraphs>55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SUNY Upstate Medical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Qinghe Meng</dc:creator>
  <cp:lastModifiedBy>Qinghe Meng</cp:lastModifiedBy>
  <cp:revision>2</cp:revision>
  <dcterms:created xsi:type="dcterms:W3CDTF">2025-02-03T21:07:03Z</dcterms:created>
  <dcterms:modified xsi:type="dcterms:W3CDTF">2025-02-04T18:24:15Z</dcterms:modified>
</cp:coreProperties>
</file>